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5"/>
  </p:notesMasterIdLst>
  <p:sldIdLst>
    <p:sldId id="276" r:id="rId2"/>
    <p:sldId id="268" r:id="rId3"/>
    <p:sldId id="269" r:id="rId4"/>
    <p:sldId id="274" r:id="rId5"/>
    <p:sldId id="278" r:id="rId6"/>
    <p:sldId id="273" r:id="rId7"/>
    <p:sldId id="272" r:id="rId8"/>
    <p:sldId id="275" r:id="rId9"/>
    <p:sldId id="270" r:id="rId10"/>
    <p:sldId id="271" r:id="rId11"/>
    <p:sldId id="277" r:id="rId12"/>
    <p:sldId id="279" r:id="rId13"/>
    <p:sldId id="280" r:id="rId1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929C2F8-1085-4EF4-9844-26176A2D3EB6}" v="21" dt="2023-07-31T09:17:55.983"/>
  </p1510:revLst>
</p1510:revInfo>
</file>

<file path=ppt/tableStyles.xml><?xml version="1.0" encoding="utf-8"?>
<a:tblStyleLst xmlns:a="http://schemas.openxmlformats.org/drawingml/2006/main" def="{5C22544A-7EE6-4342-B048-85BDC9FD1C3A}">
  <a:tblStyle styleId="{616DA210-FB5B-4158-B5E0-FEB733F419BA}" styleName="Stile chiaro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D7AC3CCA-C797-4891-BE02-D94E43425B78}" styleName="Stile medio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7E9639D4-E3E2-4D34-9284-5A2195B3D0D7}" styleName="Stile chi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Stile medio 2 - Colore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793D81CF-94F2-401A-BA57-92F5A7B2D0C5}" styleName="Stile medio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8EC20E35-A176-4012-BC5E-935CFFF8708E}" styleName="Stile medio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980" autoAdjust="0"/>
    <p:restoredTop sz="96344" autoAdjust="0"/>
  </p:normalViewPr>
  <p:slideViewPr>
    <p:cSldViewPr snapToGrid="0">
      <p:cViewPr>
        <p:scale>
          <a:sx n="140" d="100"/>
          <a:sy n="140" d="100"/>
        </p:scale>
        <p:origin x="1620" y="-3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microsoft.com/office/2015/10/relationships/revisionInfo" Target="revisionInfo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20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lavia Trionfetti" userId="848a2581ed430fde" providerId="LiveId" clId="{B929C2F8-1085-4EF4-9844-26176A2D3EB6}"/>
    <pc:docChg chg="undo custSel addSld delSld modSld">
      <pc:chgData name="Flavia Trionfetti" userId="848a2581ed430fde" providerId="LiveId" clId="{B929C2F8-1085-4EF4-9844-26176A2D3EB6}" dt="2023-07-31T09:18:43.281" v="253"/>
      <pc:docMkLst>
        <pc:docMk/>
      </pc:docMkLst>
      <pc:sldChg chg="delSp new del mod modClrScheme chgLayout">
        <pc:chgData name="Flavia Trionfetti" userId="848a2581ed430fde" providerId="LiveId" clId="{B929C2F8-1085-4EF4-9844-26176A2D3EB6}" dt="2023-07-29T17:20:06.317" v="3" actId="47"/>
        <pc:sldMkLst>
          <pc:docMk/>
          <pc:sldMk cId="1564553285" sldId="256"/>
        </pc:sldMkLst>
        <pc:spChg chg="del">
          <ac:chgData name="Flavia Trionfetti" userId="848a2581ed430fde" providerId="LiveId" clId="{B929C2F8-1085-4EF4-9844-26176A2D3EB6}" dt="2023-07-29T17:12:29.171" v="1" actId="700"/>
          <ac:spMkLst>
            <pc:docMk/>
            <pc:sldMk cId="1564553285" sldId="256"/>
            <ac:spMk id="2" creationId="{72D0C2BF-1738-BC1B-8768-8B3821723AB2}"/>
          </ac:spMkLst>
        </pc:spChg>
        <pc:spChg chg="del">
          <ac:chgData name="Flavia Trionfetti" userId="848a2581ed430fde" providerId="LiveId" clId="{B929C2F8-1085-4EF4-9844-26176A2D3EB6}" dt="2023-07-29T17:12:29.171" v="1" actId="700"/>
          <ac:spMkLst>
            <pc:docMk/>
            <pc:sldMk cId="1564553285" sldId="256"/>
            <ac:spMk id="3" creationId="{758AB5B3-D0B5-410A-1DE2-CF733E864486}"/>
          </ac:spMkLst>
        </pc:spChg>
      </pc:sldChg>
      <pc:sldChg chg="modSp add mod">
        <pc:chgData name="Flavia Trionfetti" userId="848a2581ed430fde" providerId="LiveId" clId="{B929C2F8-1085-4EF4-9844-26176A2D3EB6}" dt="2023-07-29T17:23:41.502" v="8" actId="20577"/>
        <pc:sldMkLst>
          <pc:docMk/>
          <pc:sldMk cId="2883967138" sldId="257"/>
        </pc:sldMkLst>
        <pc:spChg chg="mod">
          <ac:chgData name="Flavia Trionfetti" userId="848a2581ed430fde" providerId="LiveId" clId="{B929C2F8-1085-4EF4-9844-26176A2D3EB6}" dt="2023-07-29T17:23:41.502" v="8" actId="20577"/>
          <ac:spMkLst>
            <pc:docMk/>
            <pc:sldMk cId="2883967138" sldId="257"/>
            <ac:spMk id="33" creationId="{2FB24937-0019-BD5D-0E87-C7DFB3B3E7FF}"/>
          </ac:spMkLst>
        </pc:spChg>
      </pc:sldChg>
      <pc:sldChg chg="modSp add mod">
        <pc:chgData name="Flavia Trionfetti" userId="848a2581ed430fde" providerId="LiveId" clId="{B929C2F8-1085-4EF4-9844-26176A2D3EB6}" dt="2023-07-29T17:23:36.373" v="5" actId="20577"/>
        <pc:sldMkLst>
          <pc:docMk/>
          <pc:sldMk cId="606462679" sldId="258"/>
        </pc:sldMkLst>
        <pc:spChg chg="mod">
          <ac:chgData name="Flavia Trionfetti" userId="848a2581ed430fde" providerId="LiveId" clId="{B929C2F8-1085-4EF4-9844-26176A2D3EB6}" dt="2023-07-29T17:23:36.373" v="5" actId="20577"/>
          <ac:spMkLst>
            <pc:docMk/>
            <pc:sldMk cId="606462679" sldId="258"/>
            <ac:spMk id="13" creationId="{83D2101A-AF5C-71DA-7ED2-67FF4AF2F6C0}"/>
          </ac:spMkLst>
        </pc:spChg>
      </pc:sldChg>
      <pc:sldChg chg="modSp add mod">
        <pc:chgData name="Flavia Trionfetti" userId="848a2581ed430fde" providerId="LiveId" clId="{B929C2F8-1085-4EF4-9844-26176A2D3EB6}" dt="2023-07-31T09:11:05.834" v="220" actId="20577"/>
        <pc:sldMkLst>
          <pc:docMk/>
          <pc:sldMk cId="2740783185" sldId="265"/>
        </pc:sldMkLst>
        <pc:spChg chg="mod">
          <ac:chgData name="Flavia Trionfetti" userId="848a2581ed430fde" providerId="LiveId" clId="{B929C2F8-1085-4EF4-9844-26176A2D3EB6}" dt="2023-07-31T09:11:05.834" v="220" actId="20577"/>
          <ac:spMkLst>
            <pc:docMk/>
            <pc:sldMk cId="2740783185" sldId="265"/>
            <ac:spMk id="53" creationId="{00000000-0000-0000-0000-000000000000}"/>
          </ac:spMkLst>
        </pc:spChg>
        <pc:spChg chg="mod">
          <ac:chgData name="Flavia Trionfetti" userId="848a2581ed430fde" providerId="LiveId" clId="{B929C2F8-1085-4EF4-9844-26176A2D3EB6}" dt="2023-07-29T17:24:00.295" v="18" actId="20577"/>
          <ac:spMkLst>
            <pc:docMk/>
            <pc:sldMk cId="2740783185" sldId="265"/>
            <ac:spMk id="61" creationId="{2FB24937-0019-BD5D-0E87-C7DFB3B3E7FF}"/>
          </ac:spMkLst>
        </pc:spChg>
      </pc:sldChg>
      <pc:sldChg chg="modSp add mod">
        <pc:chgData name="Flavia Trionfetti" userId="848a2581ed430fde" providerId="LiveId" clId="{B929C2F8-1085-4EF4-9844-26176A2D3EB6}" dt="2023-07-29T17:24:06.499" v="21" actId="20577"/>
        <pc:sldMkLst>
          <pc:docMk/>
          <pc:sldMk cId="3584703059" sldId="266"/>
        </pc:sldMkLst>
        <pc:spChg chg="mod">
          <ac:chgData name="Flavia Trionfetti" userId="848a2581ed430fde" providerId="LiveId" clId="{B929C2F8-1085-4EF4-9844-26176A2D3EB6}" dt="2023-07-29T17:24:06.499" v="21" actId="20577"/>
          <ac:spMkLst>
            <pc:docMk/>
            <pc:sldMk cId="3584703059" sldId="266"/>
            <ac:spMk id="40" creationId="{2FB24937-0019-BD5D-0E87-C7DFB3B3E7FF}"/>
          </ac:spMkLst>
        </pc:spChg>
      </pc:sldChg>
      <pc:sldChg chg="addSp delSp modSp add mod">
        <pc:chgData name="Flavia Trionfetti" userId="848a2581ed430fde" providerId="LiveId" clId="{B929C2F8-1085-4EF4-9844-26176A2D3EB6}" dt="2023-07-30T10:54:24.963" v="31" actId="22"/>
        <pc:sldMkLst>
          <pc:docMk/>
          <pc:sldMk cId="1972786940" sldId="267"/>
        </pc:sldMkLst>
        <pc:spChg chg="add">
          <ac:chgData name="Flavia Trionfetti" userId="848a2581ed430fde" providerId="LiveId" clId="{B929C2F8-1085-4EF4-9844-26176A2D3EB6}" dt="2023-07-30T10:54:17.848" v="25" actId="22"/>
          <ac:spMkLst>
            <pc:docMk/>
            <pc:sldMk cId="1972786940" sldId="267"/>
            <ac:spMk id="11" creationId="{967BCCF9-F43C-32A9-291A-0F5C74C354FC}"/>
          </ac:spMkLst>
        </pc:spChg>
        <pc:spChg chg="add del mod">
          <ac:chgData name="Flavia Trionfetti" userId="848a2581ed430fde" providerId="LiveId" clId="{B929C2F8-1085-4EF4-9844-26176A2D3EB6}" dt="2023-07-30T10:54:24.963" v="31" actId="22"/>
          <ac:spMkLst>
            <pc:docMk/>
            <pc:sldMk cId="1972786940" sldId="267"/>
            <ac:spMk id="13" creationId="{BABBFAB5-831A-8E9B-3C15-3136234F898D}"/>
          </ac:spMkLst>
        </pc:spChg>
        <pc:spChg chg="mod">
          <ac:chgData name="Flavia Trionfetti" userId="848a2581ed430fde" providerId="LiveId" clId="{B929C2F8-1085-4EF4-9844-26176A2D3EB6}" dt="2023-07-29T17:24:11.622" v="24" actId="20577"/>
          <ac:spMkLst>
            <pc:docMk/>
            <pc:sldMk cId="1972786940" sldId="267"/>
            <ac:spMk id="47" creationId="{2FB24937-0019-BD5D-0E87-C7DFB3B3E7FF}"/>
          </ac:spMkLst>
        </pc:spChg>
      </pc:sldChg>
      <pc:sldChg chg="modSp add mod">
        <pc:chgData name="Flavia Trionfetti" userId="848a2581ed430fde" providerId="LiveId" clId="{B929C2F8-1085-4EF4-9844-26176A2D3EB6}" dt="2023-07-29T17:23:54.330" v="15" actId="20577"/>
        <pc:sldMkLst>
          <pc:docMk/>
          <pc:sldMk cId="1179536846" sldId="268"/>
        </pc:sldMkLst>
        <pc:spChg chg="mod">
          <ac:chgData name="Flavia Trionfetti" userId="848a2581ed430fde" providerId="LiveId" clId="{B929C2F8-1085-4EF4-9844-26176A2D3EB6}" dt="2023-07-29T17:23:54.330" v="15" actId="20577"/>
          <ac:spMkLst>
            <pc:docMk/>
            <pc:sldMk cId="1179536846" sldId="268"/>
            <ac:spMk id="3" creationId="{2FB24937-0019-BD5D-0E87-C7DFB3B3E7FF}"/>
          </ac:spMkLst>
        </pc:spChg>
      </pc:sldChg>
      <pc:sldChg chg="modSp add mod">
        <pc:chgData name="Flavia Trionfetti" userId="848a2581ed430fde" providerId="LiveId" clId="{B929C2F8-1085-4EF4-9844-26176A2D3EB6}" dt="2023-07-29T17:23:46.498" v="11" actId="20577"/>
        <pc:sldMkLst>
          <pc:docMk/>
          <pc:sldMk cId="1548005585" sldId="269"/>
        </pc:sldMkLst>
        <pc:spChg chg="mod">
          <ac:chgData name="Flavia Trionfetti" userId="848a2581ed430fde" providerId="LiveId" clId="{B929C2F8-1085-4EF4-9844-26176A2D3EB6}" dt="2023-07-29T17:23:46.498" v="11" actId="20577"/>
          <ac:spMkLst>
            <pc:docMk/>
            <pc:sldMk cId="1548005585" sldId="269"/>
            <ac:spMk id="15" creationId="{94DC8305-759E-01B7-A7AD-6303BF1E4990}"/>
          </ac:spMkLst>
        </pc:spChg>
      </pc:sldChg>
      <pc:sldChg chg="addSp modSp new mod">
        <pc:chgData name="Flavia Trionfetti" userId="848a2581ed430fde" providerId="LiveId" clId="{B929C2F8-1085-4EF4-9844-26176A2D3EB6}" dt="2023-07-30T11:02:00.398" v="122" actId="20577"/>
        <pc:sldMkLst>
          <pc:docMk/>
          <pc:sldMk cId="1910732905" sldId="270"/>
        </pc:sldMkLst>
        <pc:spChg chg="add mod">
          <ac:chgData name="Flavia Trionfetti" userId="848a2581ed430fde" providerId="LiveId" clId="{B929C2F8-1085-4EF4-9844-26176A2D3EB6}" dt="2023-07-30T11:02:00.398" v="122" actId="20577"/>
          <ac:spMkLst>
            <pc:docMk/>
            <pc:sldMk cId="1910732905" sldId="270"/>
            <ac:spMk id="2" creationId="{EB152C08-3FCE-A9B2-DE24-B7DEFE44A379}"/>
          </ac:spMkLst>
        </pc:spChg>
        <pc:picChg chg="add mod">
          <ac:chgData name="Flavia Trionfetti" userId="848a2581ed430fde" providerId="LiveId" clId="{B929C2F8-1085-4EF4-9844-26176A2D3EB6}" dt="2023-07-30T10:58:40.227" v="71" actId="1076"/>
          <ac:picMkLst>
            <pc:docMk/>
            <pc:sldMk cId="1910732905" sldId="270"/>
            <ac:picMk id="1026" creationId="{9465CA91-5419-51F8-6AA7-E427BD6C5201}"/>
          </ac:picMkLst>
        </pc:picChg>
      </pc:sldChg>
      <pc:sldChg chg="addSp modSp new mod">
        <pc:chgData name="Flavia Trionfetti" userId="848a2581ed430fde" providerId="LiveId" clId="{B929C2F8-1085-4EF4-9844-26176A2D3EB6}" dt="2023-07-30T11:02:27.443" v="208" actId="20577"/>
        <pc:sldMkLst>
          <pc:docMk/>
          <pc:sldMk cId="1701433413" sldId="271"/>
        </pc:sldMkLst>
        <pc:spChg chg="add mod">
          <ac:chgData name="Flavia Trionfetti" userId="848a2581ed430fde" providerId="LiveId" clId="{B929C2F8-1085-4EF4-9844-26176A2D3EB6}" dt="2023-07-30T10:55:03.540" v="41" actId="14100"/>
          <ac:spMkLst>
            <pc:docMk/>
            <pc:sldMk cId="1701433413" sldId="271"/>
            <ac:spMk id="3" creationId="{EEEA1FCE-1CA1-2213-3E27-AAA5E1A5677E}"/>
          </ac:spMkLst>
        </pc:spChg>
        <pc:spChg chg="add mod">
          <ac:chgData name="Flavia Trionfetti" userId="848a2581ed430fde" providerId="LiveId" clId="{B929C2F8-1085-4EF4-9844-26176A2D3EB6}" dt="2023-07-30T11:02:27.443" v="208" actId="20577"/>
          <ac:spMkLst>
            <pc:docMk/>
            <pc:sldMk cId="1701433413" sldId="271"/>
            <ac:spMk id="4" creationId="{A28AE39E-9ED2-DC3E-CE29-A4AF1A850AE4}"/>
          </ac:spMkLst>
        </pc:spChg>
        <pc:graphicFrameChg chg="add mod modGraphic">
          <ac:chgData name="Flavia Trionfetti" userId="848a2581ed430fde" providerId="LiveId" clId="{B929C2F8-1085-4EF4-9844-26176A2D3EB6}" dt="2023-07-30T11:02:08.846" v="124" actId="1076"/>
          <ac:graphicFrameMkLst>
            <pc:docMk/>
            <pc:sldMk cId="1701433413" sldId="271"/>
            <ac:graphicFrameMk id="2" creationId="{85818697-29B1-E5A2-F134-9A2772D9B15C}"/>
          </ac:graphicFrameMkLst>
        </pc:graphicFrameChg>
      </pc:sldChg>
      <pc:sldChg chg="addSp modSp new mod">
        <pc:chgData name="Flavia Trionfetti" userId="848a2581ed430fde" providerId="LiveId" clId="{B929C2F8-1085-4EF4-9844-26176A2D3EB6}" dt="2023-07-31T09:18:43.281" v="253"/>
        <pc:sldMkLst>
          <pc:docMk/>
          <pc:sldMk cId="904550341" sldId="272"/>
        </pc:sldMkLst>
        <pc:spChg chg="add mod">
          <ac:chgData name="Flavia Trionfetti" userId="848a2581ed430fde" providerId="LiveId" clId="{B929C2F8-1085-4EF4-9844-26176A2D3EB6}" dt="2023-07-31T09:18:43.281" v="253"/>
          <ac:spMkLst>
            <pc:docMk/>
            <pc:sldMk cId="904550341" sldId="272"/>
            <ac:spMk id="2" creationId="{6492814A-A57B-7D95-417E-BC715D74EC14}"/>
          </ac:spMkLst>
        </pc:spChg>
        <pc:spChg chg="add mod">
          <ac:chgData name="Flavia Trionfetti" userId="848a2581ed430fde" providerId="LiveId" clId="{B929C2F8-1085-4EF4-9844-26176A2D3EB6}" dt="2023-07-31T09:17:55.983" v="248" actId="14100"/>
          <ac:spMkLst>
            <pc:docMk/>
            <pc:sldMk cId="904550341" sldId="272"/>
            <ac:spMk id="4" creationId="{0A8A413F-CA40-B2EB-7FDA-13A67D9E1696}"/>
          </ac:spMkLst>
        </pc:spChg>
        <pc:graphicFrameChg chg="add mod modGraphic">
          <ac:chgData name="Flavia Trionfetti" userId="848a2581ed430fde" providerId="LiveId" clId="{B929C2F8-1085-4EF4-9844-26176A2D3EB6}" dt="2023-07-31T09:18:07.188" v="251" actId="1076"/>
          <ac:graphicFrameMkLst>
            <pc:docMk/>
            <pc:sldMk cId="904550341" sldId="272"/>
            <ac:graphicFrameMk id="3" creationId="{2FAB7886-DADF-64B1-0FAF-4C570E6F43A5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 dirty="0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A28849-168C-4A50-B408-10919E3C8B27}" type="datetimeFigureOut">
              <a:rPr lang="it-IT" smtClean="0"/>
              <a:t>26/05/2025</a:t>
            </a:fld>
            <a:endParaRPr lang="it-IT" dirty="0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 dirty="0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 dirty="0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231E27A-5B1C-4845-91F6-ED6EB32FE1AD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1202276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58E3A-C1D8-42AD-84B1-F2454143C861}" type="datetimeFigureOut">
              <a:rPr lang="it-IT" smtClean="0"/>
              <a:t>26/05/2025</a:t>
            </a:fld>
            <a:endParaRPr lang="it-IT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1EB7A-29BF-488B-8A11-A9A86050F5BE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4854465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58E3A-C1D8-42AD-84B1-F2454143C861}" type="datetimeFigureOut">
              <a:rPr lang="it-IT" smtClean="0"/>
              <a:t>26/05/2025</a:t>
            </a:fld>
            <a:endParaRPr lang="it-IT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1EB7A-29BF-488B-8A11-A9A86050F5BE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2561685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58E3A-C1D8-42AD-84B1-F2454143C861}" type="datetimeFigureOut">
              <a:rPr lang="it-IT" smtClean="0"/>
              <a:t>26/05/2025</a:t>
            </a:fld>
            <a:endParaRPr lang="it-IT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1EB7A-29BF-488B-8A11-A9A86050F5BE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41975671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58E3A-C1D8-42AD-84B1-F2454143C861}" type="datetimeFigureOut">
              <a:rPr lang="it-IT" smtClean="0"/>
              <a:t>26/05/2025</a:t>
            </a:fld>
            <a:endParaRPr lang="it-IT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1EB7A-29BF-488B-8A11-A9A86050F5BE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9094678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58E3A-C1D8-42AD-84B1-F2454143C861}" type="datetimeFigureOut">
              <a:rPr lang="it-IT" smtClean="0"/>
              <a:t>26/05/2025</a:t>
            </a:fld>
            <a:endParaRPr lang="it-IT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1EB7A-29BF-488B-8A11-A9A86050F5BE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9317058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58E3A-C1D8-42AD-84B1-F2454143C861}" type="datetimeFigureOut">
              <a:rPr lang="it-IT" smtClean="0"/>
              <a:t>26/05/2025</a:t>
            </a:fld>
            <a:endParaRPr lang="it-IT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1EB7A-29BF-488B-8A11-A9A86050F5BE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7070640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58E3A-C1D8-42AD-84B1-F2454143C861}" type="datetimeFigureOut">
              <a:rPr lang="it-IT" smtClean="0"/>
              <a:t>26/05/2025</a:t>
            </a:fld>
            <a:endParaRPr lang="it-IT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1EB7A-29BF-488B-8A11-A9A86050F5BE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6315701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58E3A-C1D8-42AD-84B1-F2454143C861}" type="datetimeFigureOut">
              <a:rPr lang="it-IT" smtClean="0"/>
              <a:t>26/05/2025</a:t>
            </a:fld>
            <a:endParaRPr lang="it-IT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1EB7A-29BF-488B-8A11-A9A86050F5BE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6406627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58E3A-C1D8-42AD-84B1-F2454143C861}" type="datetimeFigureOut">
              <a:rPr lang="it-IT" smtClean="0"/>
              <a:t>26/05/2025</a:t>
            </a:fld>
            <a:endParaRPr lang="it-IT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1EB7A-29BF-488B-8A11-A9A86050F5BE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9330973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58E3A-C1D8-42AD-84B1-F2454143C861}" type="datetimeFigureOut">
              <a:rPr lang="it-IT" smtClean="0"/>
              <a:t>26/05/2025</a:t>
            </a:fld>
            <a:endParaRPr lang="it-IT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1EB7A-29BF-488B-8A11-A9A86050F5BE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1388304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 dirty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58E3A-C1D8-42AD-84B1-F2454143C861}" type="datetimeFigureOut">
              <a:rPr lang="it-IT" smtClean="0"/>
              <a:t>26/05/2025</a:t>
            </a:fld>
            <a:endParaRPr lang="it-IT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1EB7A-29BF-488B-8A11-A9A86050F5BE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7717734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258E3A-C1D8-42AD-84B1-F2454143C861}" type="datetimeFigureOut">
              <a:rPr lang="it-IT" smtClean="0"/>
              <a:t>26/05/2025</a:t>
            </a:fld>
            <a:endParaRPr lang="it-IT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41EB7A-29BF-488B-8A11-A9A86050F5BE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2643247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B9F128C6-1BE5-48EC-AFFE-A2FB4AEF6FC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6811" y="192639"/>
            <a:ext cx="5436977" cy="43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AA33ADE5-0495-484E-B873-81C616D193BD}"/>
              </a:ext>
            </a:extLst>
          </p:cNvPr>
          <p:cNvSpPr txBox="1"/>
          <p:nvPr/>
        </p:nvSpPr>
        <p:spPr>
          <a:xfrm>
            <a:off x="2358705" y="2598919"/>
            <a:ext cx="556179" cy="307512"/>
          </a:xfrm>
          <a:prstGeom prst="rect">
            <a:avLst/>
          </a:prstGeom>
          <a:noFill/>
          <a:ln w="19050">
            <a:solidFill>
              <a:srgbClr val="00B0F0"/>
            </a:solidFill>
          </a:ln>
        </p:spPr>
        <p:txBody>
          <a:bodyPr wrap="square" rtlCol="0">
            <a:spAutoFit/>
          </a:bodyPr>
          <a:lstStyle/>
          <a:p>
            <a:endParaRPr lang="it-IT" dirty="0"/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CB9BB14F-6CAD-44AC-B967-2F2925020302}"/>
              </a:ext>
            </a:extLst>
          </p:cNvPr>
          <p:cNvSpPr txBox="1"/>
          <p:nvPr/>
        </p:nvSpPr>
        <p:spPr>
          <a:xfrm>
            <a:off x="954299" y="2583265"/>
            <a:ext cx="1036918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it-IT" dirty="0"/>
              <a:t>E-CAD</a:t>
            </a:r>
          </a:p>
          <a:p>
            <a:r>
              <a:rPr lang="it-IT" dirty="0"/>
              <a:t>FIG 2B</a:t>
            </a:r>
          </a:p>
        </p:txBody>
      </p:sp>
      <p:pic>
        <p:nvPicPr>
          <p:cNvPr id="14" name="Immagine 13">
            <a:extLst>
              <a:ext uri="{FF2B5EF4-FFF2-40B4-BE49-F238E27FC236}">
                <a16:creationId xmlns:a16="http://schemas.microsoft.com/office/drawing/2014/main" id="{15462F89-7429-4E6A-9838-5EEB819FC9F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6811" y="4641599"/>
            <a:ext cx="5436977" cy="3138175"/>
          </a:xfrm>
          <a:prstGeom prst="rect">
            <a:avLst/>
          </a:prstGeom>
        </p:spPr>
      </p:pic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F739FC44-8562-4BDD-B7CE-D98DAEF33488}"/>
              </a:ext>
            </a:extLst>
          </p:cNvPr>
          <p:cNvSpPr txBox="1"/>
          <p:nvPr/>
        </p:nvSpPr>
        <p:spPr>
          <a:xfrm>
            <a:off x="1024457" y="7307329"/>
            <a:ext cx="1286860" cy="338554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it-IT" sz="1600" dirty="0">
                <a:solidFill>
                  <a:schemeClr val="bg1"/>
                </a:solidFill>
              </a:rPr>
              <a:t>E-CAD FIG 2B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895DA314-3806-495A-98D4-A303E0D3D155}"/>
              </a:ext>
            </a:extLst>
          </p:cNvPr>
          <p:cNvSpPr txBox="1"/>
          <p:nvPr/>
        </p:nvSpPr>
        <p:spPr>
          <a:xfrm>
            <a:off x="1349298" y="6684200"/>
            <a:ext cx="885060" cy="383387"/>
          </a:xfrm>
          <a:prstGeom prst="rect">
            <a:avLst/>
          </a:prstGeom>
          <a:noFill/>
          <a:ln w="19050">
            <a:solidFill>
              <a:srgbClr val="00B0F0"/>
            </a:solidFill>
          </a:ln>
        </p:spPr>
        <p:txBody>
          <a:bodyPr wrap="square" rtlCol="0">
            <a:spAutoFit/>
          </a:bodyPr>
          <a:lstStyle/>
          <a:p>
            <a:endParaRPr lang="it-IT" dirty="0"/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6E078169-7C8B-49A1-9425-F3BCA6F08418}"/>
              </a:ext>
            </a:extLst>
          </p:cNvPr>
          <p:cNvSpPr txBox="1"/>
          <p:nvPr/>
        </p:nvSpPr>
        <p:spPr>
          <a:xfrm>
            <a:off x="1025108" y="6940511"/>
            <a:ext cx="3955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75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0EB546F2-24BA-4C75-A1E7-743C4D1D3F5E}"/>
              </a:ext>
            </a:extLst>
          </p:cNvPr>
          <p:cNvSpPr txBox="1"/>
          <p:nvPr/>
        </p:nvSpPr>
        <p:spPr>
          <a:xfrm>
            <a:off x="1007234" y="6772113"/>
            <a:ext cx="6219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100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4AE69458-A1D0-4DC4-AD1E-FE3CA27BD851}"/>
              </a:ext>
            </a:extLst>
          </p:cNvPr>
          <p:cNvSpPr txBox="1"/>
          <p:nvPr/>
        </p:nvSpPr>
        <p:spPr>
          <a:xfrm>
            <a:off x="1010214" y="6640761"/>
            <a:ext cx="5653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140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B99C3FDB-77EF-4BD3-A903-EACC928B8384}"/>
              </a:ext>
            </a:extLst>
          </p:cNvPr>
          <p:cNvSpPr txBox="1"/>
          <p:nvPr/>
        </p:nvSpPr>
        <p:spPr>
          <a:xfrm>
            <a:off x="1007234" y="6542050"/>
            <a:ext cx="8716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180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C26BA25E-33AA-4D8E-879A-FD16DC66C67C}"/>
              </a:ext>
            </a:extLst>
          </p:cNvPr>
          <p:cNvSpPr txBox="1"/>
          <p:nvPr/>
        </p:nvSpPr>
        <p:spPr>
          <a:xfrm>
            <a:off x="4611268" y="7522772"/>
            <a:ext cx="14125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ng exposure</a:t>
            </a:r>
          </a:p>
        </p:txBody>
      </p:sp>
    </p:spTree>
    <p:extLst>
      <p:ext uri="{BB962C8B-B14F-4D97-AF65-F5344CB8AC3E}">
        <p14:creationId xmlns:p14="http://schemas.microsoft.com/office/powerpoint/2010/main" val="99060439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3716ED2C-81DF-4E11-858E-3701871591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9864" y="263522"/>
            <a:ext cx="5378272" cy="43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id="{79A8CA39-6DCE-4751-AAEF-24E01D7D3BE3}"/>
              </a:ext>
            </a:extLst>
          </p:cNvPr>
          <p:cNvSpPr txBox="1"/>
          <p:nvPr/>
        </p:nvSpPr>
        <p:spPr>
          <a:xfrm>
            <a:off x="3553014" y="2550732"/>
            <a:ext cx="442256" cy="36933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it-IT" dirty="0"/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D05A5511-2D1A-44AB-B2D6-0BE4AAFF69F7}"/>
              </a:ext>
            </a:extLst>
          </p:cNvPr>
          <p:cNvSpPr txBox="1"/>
          <p:nvPr/>
        </p:nvSpPr>
        <p:spPr>
          <a:xfrm>
            <a:off x="3207872" y="3525379"/>
            <a:ext cx="1132540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it-IT" dirty="0"/>
              <a:t>SMAD3</a:t>
            </a:r>
          </a:p>
          <a:p>
            <a:r>
              <a:rPr lang="it-IT" dirty="0"/>
              <a:t>SMAD2</a:t>
            </a:r>
          </a:p>
          <a:p>
            <a:r>
              <a:rPr lang="it-IT" dirty="0"/>
              <a:t>FIG 2D</a:t>
            </a:r>
          </a:p>
        </p:txBody>
      </p:sp>
      <p:pic>
        <p:nvPicPr>
          <p:cNvPr id="8" name="Immagine 7">
            <a:extLst>
              <a:ext uri="{FF2B5EF4-FFF2-40B4-BE49-F238E27FC236}">
                <a16:creationId xmlns:a16="http://schemas.microsoft.com/office/drawing/2014/main" id="{3B0475B1-432E-477D-8344-D1BF57D0824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9863" y="4717245"/>
            <a:ext cx="5378271" cy="4284565"/>
          </a:xfrm>
          <a:prstGeom prst="rect">
            <a:avLst/>
          </a:prstGeom>
        </p:spPr>
      </p:pic>
      <p:sp>
        <p:nvSpPr>
          <p:cNvPr id="9" name="CasellaDiTesto 8">
            <a:extLst>
              <a:ext uri="{FF2B5EF4-FFF2-40B4-BE49-F238E27FC236}">
                <a16:creationId xmlns:a16="http://schemas.microsoft.com/office/drawing/2014/main" id="{7F57AB07-BB27-471C-9435-2ABCC972B864}"/>
              </a:ext>
            </a:extLst>
          </p:cNvPr>
          <p:cNvSpPr txBox="1"/>
          <p:nvPr/>
        </p:nvSpPr>
        <p:spPr>
          <a:xfrm>
            <a:off x="3656608" y="7109815"/>
            <a:ext cx="338662" cy="216000"/>
          </a:xfrm>
          <a:prstGeom prst="rect">
            <a:avLst/>
          </a:prstGeom>
          <a:noFill/>
          <a:ln w="28575">
            <a:solidFill>
              <a:srgbClr val="00B0F0"/>
            </a:solidFill>
          </a:ln>
        </p:spPr>
        <p:txBody>
          <a:bodyPr wrap="square" rtlCol="0">
            <a:spAutoFit/>
          </a:bodyPr>
          <a:lstStyle/>
          <a:p>
            <a:endParaRPr lang="it-IT" dirty="0"/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3BDF1294-3C7E-4A86-BB97-9B9679629B2C}"/>
              </a:ext>
            </a:extLst>
          </p:cNvPr>
          <p:cNvSpPr txBox="1"/>
          <p:nvPr/>
        </p:nvSpPr>
        <p:spPr>
          <a:xfrm>
            <a:off x="3507658" y="7996194"/>
            <a:ext cx="1132540" cy="92333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it-IT" dirty="0">
                <a:solidFill>
                  <a:schemeClr val="bg1"/>
                </a:solidFill>
              </a:rPr>
              <a:t>SMAD3</a:t>
            </a:r>
          </a:p>
          <a:p>
            <a:r>
              <a:rPr lang="it-IT" dirty="0">
                <a:solidFill>
                  <a:schemeClr val="bg1"/>
                </a:solidFill>
              </a:rPr>
              <a:t>SMAD2</a:t>
            </a:r>
          </a:p>
          <a:p>
            <a:r>
              <a:rPr lang="it-IT" dirty="0">
                <a:solidFill>
                  <a:schemeClr val="bg1"/>
                </a:solidFill>
              </a:rPr>
              <a:t>FIG 2D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1178C8CE-481C-4AC2-A961-8D49FBE75832}"/>
              </a:ext>
            </a:extLst>
          </p:cNvPr>
          <p:cNvSpPr txBox="1"/>
          <p:nvPr/>
        </p:nvSpPr>
        <p:spPr>
          <a:xfrm>
            <a:off x="3485076" y="7029744"/>
            <a:ext cx="3386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60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71B62F95-B40B-43ED-8942-A9F54697A66E}"/>
              </a:ext>
            </a:extLst>
          </p:cNvPr>
          <p:cNvSpPr txBox="1"/>
          <p:nvPr/>
        </p:nvSpPr>
        <p:spPr>
          <a:xfrm>
            <a:off x="3495706" y="7278577"/>
            <a:ext cx="3386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45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877FF55D-9628-4CB4-AE0F-6A0608400CFE}"/>
              </a:ext>
            </a:extLst>
          </p:cNvPr>
          <p:cNvSpPr txBox="1"/>
          <p:nvPr/>
        </p:nvSpPr>
        <p:spPr>
          <a:xfrm>
            <a:off x="3497135" y="7501996"/>
            <a:ext cx="3386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35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5BA01442-D9D4-4FE7-86A7-D967B25C8FF4}"/>
              </a:ext>
            </a:extLst>
          </p:cNvPr>
          <p:cNvSpPr txBox="1"/>
          <p:nvPr/>
        </p:nvSpPr>
        <p:spPr>
          <a:xfrm>
            <a:off x="3489730" y="6895269"/>
            <a:ext cx="3386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75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E25C4FDE-8263-498A-8133-64397084AAA3}"/>
              </a:ext>
            </a:extLst>
          </p:cNvPr>
          <p:cNvSpPr txBox="1"/>
          <p:nvPr/>
        </p:nvSpPr>
        <p:spPr>
          <a:xfrm>
            <a:off x="4760800" y="8673303"/>
            <a:ext cx="14125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dium exposure</a:t>
            </a:r>
          </a:p>
        </p:txBody>
      </p:sp>
    </p:spTree>
    <p:extLst>
      <p:ext uri="{BB962C8B-B14F-4D97-AF65-F5344CB8AC3E}">
        <p14:creationId xmlns:p14="http://schemas.microsoft.com/office/powerpoint/2010/main" val="329837067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D5049DFA-3370-49B8-8969-78CAAFA8CB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2811" y="326750"/>
            <a:ext cx="5392377" cy="43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22DFDFA0-53AC-4E9D-9909-E1EC88E3F9E1}"/>
              </a:ext>
            </a:extLst>
          </p:cNvPr>
          <p:cNvSpPr txBox="1"/>
          <p:nvPr/>
        </p:nvSpPr>
        <p:spPr>
          <a:xfrm>
            <a:off x="3532239" y="2569097"/>
            <a:ext cx="434575" cy="26161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it-IT" sz="1050" dirty="0"/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C61C035E-836A-420A-8BA3-D9EC3695756D}"/>
              </a:ext>
            </a:extLst>
          </p:cNvPr>
          <p:cNvSpPr txBox="1"/>
          <p:nvPr/>
        </p:nvSpPr>
        <p:spPr>
          <a:xfrm>
            <a:off x="3532239" y="3693336"/>
            <a:ext cx="113254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it-IT" dirty="0"/>
              <a:t>GAPDH</a:t>
            </a:r>
          </a:p>
          <a:p>
            <a:r>
              <a:rPr lang="it-IT" dirty="0"/>
              <a:t>FIG 2D</a:t>
            </a:r>
          </a:p>
        </p:txBody>
      </p:sp>
      <p:pic>
        <p:nvPicPr>
          <p:cNvPr id="2" name="Immagine 1">
            <a:extLst>
              <a:ext uri="{FF2B5EF4-FFF2-40B4-BE49-F238E27FC236}">
                <a16:creationId xmlns:a16="http://schemas.microsoft.com/office/drawing/2014/main" id="{0D1C431F-6838-423E-BF0A-C133DC94A34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2811" y="4953000"/>
            <a:ext cx="5392376" cy="4745291"/>
          </a:xfrm>
          <a:prstGeom prst="rect">
            <a:avLst/>
          </a:prstGeom>
        </p:spPr>
      </p:pic>
      <p:sp>
        <p:nvSpPr>
          <p:cNvPr id="7" name="CasellaDiTesto 6">
            <a:extLst>
              <a:ext uri="{FF2B5EF4-FFF2-40B4-BE49-F238E27FC236}">
                <a16:creationId xmlns:a16="http://schemas.microsoft.com/office/drawing/2014/main" id="{070A1D62-16D7-4C8E-AC4A-1DBBAB46DBD0}"/>
              </a:ext>
            </a:extLst>
          </p:cNvPr>
          <p:cNvSpPr txBox="1"/>
          <p:nvPr/>
        </p:nvSpPr>
        <p:spPr>
          <a:xfrm>
            <a:off x="3620812" y="7477891"/>
            <a:ext cx="473206" cy="180000"/>
          </a:xfrm>
          <a:prstGeom prst="rect">
            <a:avLst/>
          </a:prstGeom>
          <a:noFill/>
          <a:ln w="28575">
            <a:solidFill>
              <a:srgbClr val="00B0F0"/>
            </a:solidFill>
          </a:ln>
        </p:spPr>
        <p:txBody>
          <a:bodyPr wrap="square" rtlCol="0">
            <a:spAutoFit/>
          </a:bodyPr>
          <a:lstStyle/>
          <a:p>
            <a:endParaRPr lang="it-IT" sz="1050" dirty="0"/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587FF39E-0B66-4CF2-ACEE-37E1C0B6C77B}"/>
              </a:ext>
            </a:extLst>
          </p:cNvPr>
          <p:cNvSpPr txBox="1"/>
          <p:nvPr/>
        </p:nvSpPr>
        <p:spPr>
          <a:xfrm>
            <a:off x="4879258" y="7444643"/>
            <a:ext cx="1132540" cy="64633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it-IT" dirty="0">
                <a:solidFill>
                  <a:schemeClr val="bg1"/>
                </a:solidFill>
              </a:rPr>
              <a:t>GAPDH</a:t>
            </a:r>
          </a:p>
          <a:p>
            <a:r>
              <a:rPr lang="it-IT" dirty="0">
                <a:solidFill>
                  <a:schemeClr val="bg1"/>
                </a:solidFill>
              </a:rPr>
              <a:t>FIG 2D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DB1D24E0-6985-4B82-B621-A1E3DA655C7C}"/>
              </a:ext>
            </a:extLst>
          </p:cNvPr>
          <p:cNvSpPr txBox="1"/>
          <p:nvPr/>
        </p:nvSpPr>
        <p:spPr>
          <a:xfrm>
            <a:off x="3421305" y="7386340"/>
            <a:ext cx="3637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/>
              <a:t>45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795307A5-FAFB-4D54-809B-37D8832695DB}"/>
              </a:ext>
            </a:extLst>
          </p:cNvPr>
          <p:cNvSpPr txBox="1"/>
          <p:nvPr/>
        </p:nvSpPr>
        <p:spPr>
          <a:xfrm>
            <a:off x="3428998" y="7553739"/>
            <a:ext cx="3637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/>
              <a:t>35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AABD5904-4F4B-4E21-8B5C-658F95E50181}"/>
              </a:ext>
            </a:extLst>
          </p:cNvPr>
          <p:cNvSpPr txBox="1"/>
          <p:nvPr/>
        </p:nvSpPr>
        <p:spPr>
          <a:xfrm>
            <a:off x="3441497" y="7742679"/>
            <a:ext cx="3637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25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5ACEF662-42C0-49F3-90B6-9030DBD6406C}"/>
              </a:ext>
            </a:extLst>
          </p:cNvPr>
          <p:cNvSpPr txBox="1"/>
          <p:nvPr/>
        </p:nvSpPr>
        <p:spPr>
          <a:xfrm>
            <a:off x="4777619" y="8240166"/>
            <a:ext cx="14125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ort exposure</a:t>
            </a:r>
          </a:p>
        </p:txBody>
      </p:sp>
    </p:spTree>
    <p:extLst>
      <p:ext uri="{BB962C8B-B14F-4D97-AF65-F5344CB8AC3E}">
        <p14:creationId xmlns:p14="http://schemas.microsoft.com/office/powerpoint/2010/main" val="144395191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1040079F-A291-4902-A5D6-937B946637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5105" y="3646226"/>
            <a:ext cx="6136981" cy="4179954"/>
          </a:xfrm>
          <a:prstGeom prst="rect">
            <a:avLst/>
          </a:prstGeom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B6369243-8BA9-46BB-8EFB-C5D820D9F16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5106" y="244258"/>
            <a:ext cx="6136981" cy="322284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CasellaDiTesto 6">
            <a:extLst>
              <a:ext uri="{FF2B5EF4-FFF2-40B4-BE49-F238E27FC236}">
                <a16:creationId xmlns:a16="http://schemas.microsoft.com/office/drawing/2014/main" id="{A784AB68-3E0F-4DDF-9AFB-B4FC32A22C23}"/>
              </a:ext>
            </a:extLst>
          </p:cNvPr>
          <p:cNvSpPr txBox="1"/>
          <p:nvPr/>
        </p:nvSpPr>
        <p:spPr>
          <a:xfrm>
            <a:off x="2579739" y="867296"/>
            <a:ext cx="1096911" cy="4852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it-IT" sz="1050" dirty="0"/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CDDACBFC-ECDA-402C-8EC7-A9043CFF82C0}"/>
              </a:ext>
            </a:extLst>
          </p:cNvPr>
          <p:cNvSpPr txBox="1"/>
          <p:nvPr/>
        </p:nvSpPr>
        <p:spPr>
          <a:xfrm>
            <a:off x="2674989" y="2340496"/>
            <a:ext cx="1096911" cy="4852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it-IT" sz="1050" dirty="0"/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C8FCF2BB-798C-49DF-A6EB-8B000EA81908}"/>
              </a:ext>
            </a:extLst>
          </p:cNvPr>
          <p:cNvSpPr txBox="1"/>
          <p:nvPr/>
        </p:nvSpPr>
        <p:spPr>
          <a:xfrm>
            <a:off x="3936828" y="786756"/>
            <a:ext cx="113254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it-IT" dirty="0"/>
              <a:t>HSP90</a:t>
            </a:r>
          </a:p>
          <a:p>
            <a:r>
              <a:rPr lang="it-IT" dirty="0"/>
              <a:t>FIG 2D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5635EA95-A718-4147-9353-AD0722678008}"/>
              </a:ext>
            </a:extLst>
          </p:cNvPr>
          <p:cNvSpPr txBox="1"/>
          <p:nvPr/>
        </p:nvSpPr>
        <p:spPr>
          <a:xfrm>
            <a:off x="3936828" y="2259956"/>
            <a:ext cx="113254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it-IT" dirty="0"/>
              <a:t>PAI-1</a:t>
            </a:r>
          </a:p>
          <a:p>
            <a:r>
              <a:rPr lang="it-IT" dirty="0"/>
              <a:t>FIG 2D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1DF39CE8-D1C1-4EEA-BB93-FA0ECDBCFA10}"/>
              </a:ext>
            </a:extLst>
          </p:cNvPr>
          <p:cNvSpPr txBox="1"/>
          <p:nvPr/>
        </p:nvSpPr>
        <p:spPr>
          <a:xfrm>
            <a:off x="2982144" y="5418971"/>
            <a:ext cx="1008011" cy="443173"/>
          </a:xfrm>
          <a:prstGeom prst="rect">
            <a:avLst/>
          </a:prstGeom>
          <a:noFill/>
          <a:ln w="28575">
            <a:solidFill>
              <a:srgbClr val="00B0F0"/>
            </a:solidFill>
          </a:ln>
        </p:spPr>
        <p:txBody>
          <a:bodyPr wrap="square" rtlCol="0">
            <a:spAutoFit/>
          </a:bodyPr>
          <a:lstStyle/>
          <a:p>
            <a:endParaRPr lang="it-IT" sz="1050" dirty="0"/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B44DDDA5-A07C-406A-8B45-8E4D1C077921}"/>
              </a:ext>
            </a:extLst>
          </p:cNvPr>
          <p:cNvSpPr txBox="1"/>
          <p:nvPr/>
        </p:nvSpPr>
        <p:spPr>
          <a:xfrm>
            <a:off x="3071044" y="6682621"/>
            <a:ext cx="1008011" cy="372229"/>
          </a:xfrm>
          <a:prstGeom prst="rect">
            <a:avLst/>
          </a:prstGeom>
          <a:noFill/>
          <a:ln w="28575">
            <a:solidFill>
              <a:srgbClr val="00B0F0"/>
            </a:solidFill>
          </a:ln>
        </p:spPr>
        <p:txBody>
          <a:bodyPr wrap="square" rtlCol="0">
            <a:spAutoFit/>
          </a:bodyPr>
          <a:lstStyle/>
          <a:p>
            <a:endParaRPr lang="it-IT" sz="1050" dirty="0"/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122AE07F-E13B-4B71-A8F7-EEEE3DDB3BF8}"/>
              </a:ext>
            </a:extLst>
          </p:cNvPr>
          <p:cNvSpPr txBox="1"/>
          <p:nvPr/>
        </p:nvSpPr>
        <p:spPr>
          <a:xfrm>
            <a:off x="2827325" y="3781302"/>
            <a:ext cx="849325" cy="584775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it-IT" sz="1600" dirty="0">
                <a:solidFill>
                  <a:schemeClr val="bg1"/>
                </a:solidFill>
              </a:rPr>
              <a:t>HSP90</a:t>
            </a:r>
          </a:p>
          <a:p>
            <a:r>
              <a:rPr lang="it-IT" sz="1600" dirty="0">
                <a:solidFill>
                  <a:schemeClr val="bg1"/>
                </a:solidFill>
              </a:rPr>
              <a:t>FIG 2D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2698ADB9-1114-46CD-890D-06BBBAEF030E}"/>
              </a:ext>
            </a:extLst>
          </p:cNvPr>
          <p:cNvSpPr txBox="1"/>
          <p:nvPr/>
        </p:nvSpPr>
        <p:spPr>
          <a:xfrm>
            <a:off x="3223444" y="7334671"/>
            <a:ext cx="713384" cy="461665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it-IT" sz="1200" dirty="0">
                <a:solidFill>
                  <a:schemeClr val="bg1"/>
                </a:solidFill>
              </a:rPr>
              <a:t>PAI-1</a:t>
            </a:r>
          </a:p>
          <a:p>
            <a:r>
              <a:rPr lang="it-IT" sz="1200" dirty="0">
                <a:solidFill>
                  <a:schemeClr val="bg1"/>
                </a:solidFill>
              </a:rPr>
              <a:t>FIG 2D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3C39F0A0-AD96-4606-9405-6FECBCA7E167}"/>
              </a:ext>
            </a:extLst>
          </p:cNvPr>
          <p:cNvSpPr txBox="1"/>
          <p:nvPr/>
        </p:nvSpPr>
        <p:spPr>
          <a:xfrm>
            <a:off x="1658524" y="7442392"/>
            <a:ext cx="14125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ort exposure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1A90AAE8-2D8E-4640-BAD3-D5170DCAABC1}"/>
              </a:ext>
            </a:extLst>
          </p:cNvPr>
          <p:cNvSpPr txBox="1"/>
          <p:nvPr/>
        </p:nvSpPr>
        <p:spPr>
          <a:xfrm>
            <a:off x="2794704" y="6712936"/>
            <a:ext cx="3222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/>
              <a:t>45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5B9430CC-4623-417A-8A48-3CF3FD092D32}"/>
              </a:ext>
            </a:extLst>
          </p:cNvPr>
          <p:cNvSpPr txBox="1"/>
          <p:nvPr/>
        </p:nvSpPr>
        <p:spPr>
          <a:xfrm>
            <a:off x="2793396" y="6390707"/>
            <a:ext cx="3222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/>
              <a:t>60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75344146-B3F0-4B00-B1A3-50B39F947FB1}"/>
              </a:ext>
            </a:extLst>
          </p:cNvPr>
          <p:cNvSpPr txBox="1"/>
          <p:nvPr/>
        </p:nvSpPr>
        <p:spPr>
          <a:xfrm>
            <a:off x="2707772" y="5654651"/>
            <a:ext cx="3222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/>
              <a:t>75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EF1301FF-47CA-48D9-AD3F-C0BBA1069877}"/>
              </a:ext>
            </a:extLst>
          </p:cNvPr>
          <p:cNvSpPr txBox="1"/>
          <p:nvPr/>
        </p:nvSpPr>
        <p:spPr>
          <a:xfrm>
            <a:off x="2659087" y="5440153"/>
            <a:ext cx="3792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/>
              <a:t>100</a:t>
            </a:r>
          </a:p>
        </p:txBody>
      </p:sp>
    </p:spTree>
    <p:extLst>
      <p:ext uri="{BB962C8B-B14F-4D97-AF65-F5344CB8AC3E}">
        <p14:creationId xmlns:p14="http://schemas.microsoft.com/office/powerpoint/2010/main" val="225421534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27B5A662-7EBA-4A45-8A94-ACF9C71C1A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2427" y="4625819"/>
            <a:ext cx="5439534" cy="2229161"/>
          </a:xfrm>
          <a:prstGeom prst="rect">
            <a:avLst/>
          </a:prstGeom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F663249A-75B6-41D2-9557-A1154EACC7A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23533" y="2241549"/>
            <a:ext cx="5438342" cy="20066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D90E4A17-7D52-4AA4-8FF8-CBA6538C1D70}"/>
              </a:ext>
            </a:extLst>
          </p:cNvPr>
          <p:cNvSpPr txBox="1"/>
          <p:nvPr/>
        </p:nvSpPr>
        <p:spPr>
          <a:xfrm>
            <a:off x="2833739" y="2905646"/>
            <a:ext cx="1096911" cy="48525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it-IT" sz="1050" dirty="0"/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07445DB9-13C0-48D2-8F76-D7933541D220}"/>
              </a:ext>
            </a:extLst>
          </p:cNvPr>
          <p:cNvSpPr txBox="1"/>
          <p:nvPr/>
        </p:nvSpPr>
        <p:spPr>
          <a:xfrm>
            <a:off x="4095578" y="2825106"/>
            <a:ext cx="113254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it-IT" dirty="0"/>
              <a:t>SNAIL</a:t>
            </a:r>
          </a:p>
          <a:p>
            <a:r>
              <a:rPr lang="it-IT" dirty="0"/>
              <a:t>FIG 2D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390F3DB6-C4DC-4A8A-97BE-8F0FE2641BD8}"/>
              </a:ext>
            </a:extLst>
          </p:cNvPr>
          <p:cNvSpPr txBox="1"/>
          <p:nvPr/>
        </p:nvSpPr>
        <p:spPr>
          <a:xfrm>
            <a:off x="2994248" y="5007496"/>
            <a:ext cx="1096911" cy="485253"/>
          </a:xfrm>
          <a:prstGeom prst="rect">
            <a:avLst/>
          </a:prstGeom>
          <a:noFill/>
          <a:ln w="28575">
            <a:solidFill>
              <a:srgbClr val="00B0F0"/>
            </a:solidFill>
          </a:ln>
        </p:spPr>
        <p:txBody>
          <a:bodyPr wrap="square" rtlCol="0">
            <a:spAutoFit/>
          </a:bodyPr>
          <a:lstStyle/>
          <a:p>
            <a:endParaRPr lang="it-IT" sz="1050" dirty="0"/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6588ADDB-C4F2-413D-AB6F-99D41A91C095}"/>
              </a:ext>
            </a:extLst>
          </p:cNvPr>
          <p:cNvSpPr txBox="1"/>
          <p:nvPr/>
        </p:nvSpPr>
        <p:spPr>
          <a:xfrm>
            <a:off x="3930650" y="6120756"/>
            <a:ext cx="1132540" cy="64633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it-IT" dirty="0">
                <a:solidFill>
                  <a:schemeClr val="bg1"/>
                </a:solidFill>
              </a:rPr>
              <a:t>SNAIL</a:t>
            </a:r>
          </a:p>
          <a:p>
            <a:r>
              <a:rPr lang="it-IT" dirty="0">
                <a:solidFill>
                  <a:schemeClr val="bg1"/>
                </a:solidFill>
              </a:rPr>
              <a:t>FIG 2D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AA8D6F32-8130-4444-B885-E79F3817BCB9}"/>
              </a:ext>
            </a:extLst>
          </p:cNvPr>
          <p:cNvSpPr txBox="1"/>
          <p:nvPr/>
        </p:nvSpPr>
        <p:spPr>
          <a:xfrm>
            <a:off x="1969674" y="6443921"/>
            <a:ext cx="14125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dium exposure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F2821A98-DFA6-42CD-8A82-04C583FEAA97}"/>
              </a:ext>
            </a:extLst>
          </p:cNvPr>
          <p:cNvSpPr txBox="1"/>
          <p:nvPr/>
        </p:nvSpPr>
        <p:spPr>
          <a:xfrm>
            <a:off x="2696563" y="5400416"/>
            <a:ext cx="4680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>
                <a:solidFill>
                  <a:schemeClr val="bg1"/>
                </a:solidFill>
              </a:rPr>
              <a:t>25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BA250B6A-57B6-416B-8FBF-DAF5600DF534}"/>
              </a:ext>
            </a:extLst>
          </p:cNvPr>
          <p:cNvSpPr txBox="1"/>
          <p:nvPr/>
        </p:nvSpPr>
        <p:spPr>
          <a:xfrm>
            <a:off x="2703206" y="4974824"/>
            <a:ext cx="3818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>
                <a:solidFill>
                  <a:schemeClr val="bg1"/>
                </a:solidFill>
              </a:rPr>
              <a:t>35</a:t>
            </a:r>
          </a:p>
        </p:txBody>
      </p:sp>
    </p:spTree>
    <p:extLst>
      <p:ext uri="{BB962C8B-B14F-4D97-AF65-F5344CB8AC3E}">
        <p14:creationId xmlns:p14="http://schemas.microsoft.com/office/powerpoint/2010/main" val="38883928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D4A7B0FD-31F7-4A9C-B7C3-E858757D03F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4446" y="952766"/>
            <a:ext cx="5418960" cy="43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2A3BA86E-71FE-4171-BBCD-92BC438F3B70}"/>
              </a:ext>
            </a:extLst>
          </p:cNvPr>
          <p:cNvSpPr txBox="1"/>
          <p:nvPr/>
        </p:nvSpPr>
        <p:spPr>
          <a:xfrm>
            <a:off x="1512047" y="5904755"/>
            <a:ext cx="68729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it-IT" dirty="0"/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34BB23F1-749C-4978-A395-0B018BA6608C}"/>
              </a:ext>
            </a:extLst>
          </p:cNvPr>
          <p:cNvSpPr txBox="1"/>
          <p:nvPr/>
        </p:nvSpPr>
        <p:spPr>
          <a:xfrm>
            <a:off x="947271" y="3916189"/>
            <a:ext cx="987855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it-IT" dirty="0"/>
              <a:t>TGFBRI FIG 2B</a:t>
            </a:r>
          </a:p>
        </p:txBody>
      </p:sp>
      <p:pic>
        <p:nvPicPr>
          <p:cNvPr id="7" name="Immagine 6">
            <a:extLst>
              <a:ext uri="{FF2B5EF4-FFF2-40B4-BE49-F238E27FC236}">
                <a16:creationId xmlns:a16="http://schemas.microsoft.com/office/drawing/2014/main" id="{B0D74BDC-F791-4AE5-BFB5-9CBC193B1A2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84446" y="5483429"/>
            <a:ext cx="5372880" cy="4320000"/>
          </a:xfrm>
          <a:prstGeom prst="rect">
            <a:avLst/>
          </a:prstGeom>
        </p:spPr>
      </p:pic>
      <p:sp>
        <p:nvSpPr>
          <p:cNvPr id="8" name="CasellaDiTesto 7">
            <a:extLst>
              <a:ext uri="{FF2B5EF4-FFF2-40B4-BE49-F238E27FC236}">
                <a16:creationId xmlns:a16="http://schemas.microsoft.com/office/drawing/2014/main" id="{F070370C-B711-4052-B9D8-925BB74C8F1F}"/>
              </a:ext>
            </a:extLst>
          </p:cNvPr>
          <p:cNvSpPr txBox="1"/>
          <p:nvPr/>
        </p:nvSpPr>
        <p:spPr>
          <a:xfrm>
            <a:off x="2001371" y="3870022"/>
            <a:ext cx="532279" cy="359078"/>
          </a:xfrm>
          <a:prstGeom prst="rect">
            <a:avLst/>
          </a:prstGeom>
          <a:noFill/>
          <a:ln w="28575">
            <a:solidFill>
              <a:srgbClr val="00B0F0"/>
            </a:solidFill>
          </a:ln>
        </p:spPr>
        <p:txBody>
          <a:bodyPr wrap="square" rtlCol="0">
            <a:spAutoFit/>
          </a:bodyPr>
          <a:lstStyle/>
          <a:p>
            <a:endParaRPr lang="it-IT" dirty="0"/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EC814CCC-3EB0-4CEE-81CA-A07A0C706F34}"/>
              </a:ext>
            </a:extLst>
          </p:cNvPr>
          <p:cNvSpPr txBox="1"/>
          <p:nvPr/>
        </p:nvSpPr>
        <p:spPr>
          <a:xfrm>
            <a:off x="812155" y="8481838"/>
            <a:ext cx="893493" cy="64633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it-IT" dirty="0">
                <a:solidFill>
                  <a:schemeClr val="bg1"/>
                </a:solidFill>
              </a:rPr>
              <a:t>TGFBRI FIG 2B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C761905C-AFB1-46F1-ABAA-CB67F4A9603F}"/>
              </a:ext>
            </a:extLst>
          </p:cNvPr>
          <p:cNvSpPr txBox="1"/>
          <p:nvPr/>
        </p:nvSpPr>
        <p:spPr>
          <a:xfrm>
            <a:off x="1935126" y="8435671"/>
            <a:ext cx="598525" cy="326409"/>
          </a:xfrm>
          <a:prstGeom prst="rect">
            <a:avLst/>
          </a:prstGeom>
          <a:noFill/>
          <a:ln w="28575">
            <a:solidFill>
              <a:srgbClr val="00B0F0"/>
            </a:solidFill>
          </a:ln>
        </p:spPr>
        <p:txBody>
          <a:bodyPr wrap="square" rtlCol="0">
            <a:spAutoFit/>
          </a:bodyPr>
          <a:lstStyle/>
          <a:p>
            <a:endParaRPr lang="it-IT" dirty="0"/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97401978-28A2-47B0-AF58-97971B560D38}"/>
              </a:ext>
            </a:extLst>
          </p:cNvPr>
          <p:cNvSpPr txBox="1"/>
          <p:nvPr/>
        </p:nvSpPr>
        <p:spPr>
          <a:xfrm>
            <a:off x="1731215" y="8284174"/>
            <a:ext cx="3069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60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AFF35E51-C123-45D6-B397-5E614C8C9EE1}"/>
              </a:ext>
            </a:extLst>
          </p:cNvPr>
          <p:cNvSpPr txBox="1"/>
          <p:nvPr/>
        </p:nvSpPr>
        <p:spPr>
          <a:xfrm>
            <a:off x="1721438" y="8497866"/>
            <a:ext cx="3069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45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27F63141-BA3B-479F-A9FE-7C9CE5A00529}"/>
              </a:ext>
            </a:extLst>
          </p:cNvPr>
          <p:cNvSpPr txBox="1"/>
          <p:nvPr/>
        </p:nvSpPr>
        <p:spPr>
          <a:xfrm>
            <a:off x="1709979" y="8762080"/>
            <a:ext cx="3069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35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B628C89E-B3D3-46E9-ADDF-2EB008A1BB4B}"/>
              </a:ext>
            </a:extLst>
          </p:cNvPr>
          <p:cNvSpPr txBox="1"/>
          <p:nvPr/>
        </p:nvSpPr>
        <p:spPr>
          <a:xfrm>
            <a:off x="1709504" y="9098088"/>
            <a:ext cx="3069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25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097E1DA2-6EE1-4759-9B26-490AB0470AA1}"/>
              </a:ext>
            </a:extLst>
          </p:cNvPr>
          <p:cNvSpPr txBox="1"/>
          <p:nvPr/>
        </p:nvSpPr>
        <p:spPr>
          <a:xfrm>
            <a:off x="1694427" y="9308751"/>
            <a:ext cx="3069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20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CE71EBE8-CFB3-47DE-925A-381020FBBA09}"/>
              </a:ext>
            </a:extLst>
          </p:cNvPr>
          <p:cNvSpPr txBox="1"/>
          <p:nvPr/>
        </p:nvSpPr>
        <p:spPr>
          <a:xfrm>
            <a:off x="784446" y="9557208"/>
            <a:ext cx="14125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dium exposure</a:t>
            </a:r>
          </a:p>
        </p:txBody>
      </p:sp>
    </p:spTree>
    <p:extLst>
      <p:ext uri="{BB962C8B-B14F-4D97-AF65-F5344CB8AC3E}">
        <p14:creationId xmlns:p14="http://schemas.microsoft.com/office/powerpoint/2010/main" val="16972621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07816BCF-33AD-4802-B9C5-01E996EB931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3664" y="217740"/>
            <a:ext cx="5510671" cy="43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52311D83-A5ED-4DC8-B278-A68275FAF49E}"/>
              </a:ext>
            </a:extLst>
          </p:cNvPr>
          <p:cNvSpPr txBox="1"/>
          <p:nvPr/>
        </p:nvSpPr>
        <p:spPr>
          <a:xfrm>
            <a:off x="3767376" y="1317942"/>
            <a:ext cx="556974" cy="325734"/>
          </a:xfrm>
          <a:prstGeom prst="rect">
            <a:avLst/>
          </a:prstGeom>
          <a:noFill/>
          <a:ln w="28575">
            <a:solidFill>
              <a:srgbClr val="00B0F0"/>
            </a:solidFill>
          </a:ln>
        </p:spPr>
        <p:txBody>
          <a:bodyPr wrap="square" rtlCol="0">
            <a:spAutoFit/>
          </a:bodyPr>
          <a:lstStyle/>
          <a:p>
            <a:endParaRPr lang="it-IT" dirty="0"/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1CA59EE1-413F-4B23-A5CF-75E08345D172}"/>
              </a:ext>
            </a:extLst>
          </p:cNvPr>
          <p:cNvSpPr txBox="1"/>
          <p:nvPr/>
        </p:nvSpPr>
        <p:spPr>
          <a:xfrm>
            <a:off x="3619732" y="1731409"/>
            <a:ext cx="1036918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it-IT" dirty="0"/>
              <a:t>PAI-1</a:t>
            </a:r>
          </a:p>
          <a:p>
            <a:r>
              <a:rPr lang="it-IT" dirty="0"/>
              <a:t>FIG 2B</a:t>
            </a:r>
          </a:p>
        </p:txBody>
      </p:sp>
      <p:pic>
        <p:nvPicPr>
          <p:cNvPr id="2" name="Immagine 1">
            <a:extLst>
              <a:ext uri="{FF2B5EF4-FFF2-40B4-BE49-F238E27FC236}">
                <a16:creationId xmlns:a16="http://schemas.microsoft.com/office/drawing/2014/main" id="{2632C33B-7A2B-44E9-A67F-A6303476E88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02941" y="4834967"/>
            <a:ext cx="5052115" cy="4320000"/>
          </a:xfrm>
          <a:prstGeom prst="rect">
            <a:avLst/>
          </a:prstGeom>
        </p:spPr>
      </p:pic>
      <p:sp>
        <p:nvSpPr>
          <p:cNvPr id="7" name="CasellaDiTesto 6">
            <a:extLst>
              <a:ext uri="{FF2B5EF4-FFF2-40B4-BE49-F238E27FC236}">
                <a16:creationId xmlns:a16="http://schemas.microsoft.com/office/drawing/2014/main" id="{7017FD83-DC6B-4971-BC8E-BE231B7C8F1E}"/>
              </a:ext>
            </a:extLst>
          </p:cNvPr>
          <p:cNvSpPr txBox="1"/>
          <p:nvPr/>
        </p:nvSpPr>
        <p:spPr>
          <a:xfrm>
            <a:off x="3914775" y="5942589"/>
            <a:ext cx="569941" cy="325734"/>
          </a:xfrm>
          <a:prstGeom prst="rect">
            <a:avLst/>
          </a:prstGeom>
          <a:noFill/>
          <a:ln w="28575">
            <a:solidFill>
              <a:srgbClr val="00B0F0"/>
            </a:solidFill>
          </a:ln>
        </p:spPr>
        <p:txBody>
          <a:bodyPr wrap="square" rtlCol="0">
            <a:spAutoFit/>
          </a:bodyPr>
          <a:lstStyle/>
          <a:p>
            <a:endParaRPr lang="it-IT" dirty="0"/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D0B7A53C-A1BF-4F06-8293-8ABD8BF87ACC}"/>
              </a:ext>
            </a:extLst>
          </p:cNvPr>
          <p:cNvSpPr txBox="1"/>
          <p:nvPr/>
        </p:nvSpPr>
        <p:spPr>
          <a:xfrm>
            <a:off x="5108171" y="5910314"/>
            <a:ext cx="777378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it-IT" sz="1600" dirty="0">
                <a:solidFill>
                  <a:schemeClr val="bg1"/>
                </a:solidFill>
              </a:rPr>
              <a:t>PAI-1</a:t>
            </a:r>
          </a:p>
          <a:p>
            <a:r>
              <a:rPr lang="it-IT" sz="1600" dirty="0">
                <a:solidFill>
                  <a:schemeClr val="bg1"/>
                </a:solidFill>
              </a:rPr>
              <a:t>FIG 2B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DEA2A6AB-366D-446D-9E5D-9EB7A8EF2984}"/>
              </a:ext>
            </a:extLst>
          </p:cNvPr>
          <p:cNvSpPr txBox="1"/>
          <p:nvPr/>
        </p:nvSpPr>
        <p:spPr>
          <a:xfrm>
            <a:off x="3793316" y="5724741"/>
            <a:ext cx="3355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60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EE3CD8F6-143A-4243-9E1E-DE8423458EC5}"/>
              </a:ext>
            </a:extLst>
          </p:cNvPr>
          <p:cNvSpPr txBox="1"/>
          <p:nvPr/>
        </p:nvSpPr>
        <p:spPr>
          <a:xfrm>
            <a:off x="3783539" y="5901029"/>
            <a:ext cx="3355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45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A7859CBB-0AF2-4409-ACD3-B81169A542EF}"/>
              </a:ext>
            </a:extLst>
          </p:cNvPr>
          <p:cNvSpPr txBox="1"/>
          <p:nvPr/>
        </p:nvSpPr>
        <p:spPr>
          <a:xfrm>
            <a:off x="3797016" y="6198491"/>
            <a:ext cx="3355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35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3DE42B42-1254-469B-A76F-E40AF3105C50}"/>
              </a:ext>
            </a:extLst>
          </p:cNvPr>
          <p:cNvSpPr txBox="1"/>
          <p:nvPr/>
        </p:nvSpPr>
        <p:spPr>
          <a:xfrm>
            <a:off x="3788229" y="6422281"/>
            <a:ext cx="3355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25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80D43630-D376-4711-A27B-903333F2167C}"/>
              </a:ext>
            </a:extLst>
          </p:cNvPr>
          <p:cNvSpPr txBox="1"/>
          <p:nvPr/>
        </p:nvSpPr>
        <p:spPr>
          <a:xfrm>
            <a:off x="3950390" y="7815300"/>
            <a:ext cx="14125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dium exposure</a:t>
            </a:r>
          </a:p>
        </p:txBody>
      </p:sp>
    </p:spTree>
    <p:extLst>
      <p:ext uri="{BB962C8B-B14F-4D97-AF65-F5344CB8AC3E}">
        <p14:creationId xmlns:p14="http://schemas.microsoft.com/office/powerpoint/2010/main" val="21967184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058A6AC8-FF8F-4772-8B67-A53792998A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4323" y="993193"/>
            <a:ext cx="5383306" cy="4320000"/>
          </a:xfrm>
          <a:prstGeom prst="rect">
            <a:avLst/>
          </a:prstGeom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id="{EA44FCC2-19BD-458F-AFE7-9585D5E05FFF}"/>
              </a:ext>
            </a:extLst>
          </p:cNvPr>
          <p:cNvSpPr txBox="1"/>
          <p:nvPr/>
        </p:nvSpPr>
        <p:spPr>
          <a:xfrm>
            <a:off x="1791241" y="3530599"/>
            <a:ext cx="467492" cy="28230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it-IT" dirty="0"/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C9316517-C57F-41CC-B8CE-7E0778916DEC}"/>
              </a:ext>
            </a:extLst>
          </p:cNvPr>
          <p:cNvSpPr txBox="1"/>
          <p:nvPr/>
        </p:nvSpPr>
        <p:spPr>
          <a:xfrm>
            <a:off x="832868" y="3441701"/>
            <a:ext cx="879829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it-IT" dirty="0"/>
              <a:t>GAPDH</a:t>
            </a:r>
          </a:p>
          <a:p>
            <a:r>
              <a:rPr lang="it-IT" dirty="0"/>
              <a:t>FIG 2B</a:t>
            </a:r>
          </a:p>
        </p:txBody>
      </p:sp>
      <p:pic>
        <p:nvPicPr>
          <p:cNvPr id="5" name="Immagine 4">
            <a:extLst>
              <a:ext uri="{FF2B5EF4-FFF2-40B4-BE49-F238E27FC236}">
                <a16:creationId xmlns:a16="http://schemas.microsoft.com/office/drawing/2014/main" id="{AE54B163-6369-4714-8C60-4155D7ED868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4323" y="5508319"/>
            <a:ext cx="5366330" cy="4320000"/>
          </a:xfrm>
          <a:prstGeom prst="rect">
            <a:avLst/>
          </a:prstGeom>
        </p:spPr>
      </p:pic>
      <p:sp>
        <p:nvSpPr>
          <p:cNvPr id="10" name="CasellaDiTesto 9">
            <a:extLst>
              <a:ext uri="{FF2B5EF4-FFF2-40B4-BE49-F238E27FC236}">
                <a16:creationId xmlns:a16="http://schemas.microsoft.com/office/drawing/2014/main" id="{041E6900-D939-4FD3-A6FD-F83F2F75C75C}"/>
              </a:ext>
            </a:extLst>
          </p:cNvPr>
          <p:cNvSpPr txBox="1"/>
          <p:nvPr/>
        </p:nvSpPr>
        <p:spPr>
          <a:xfrm>
            <a:off x="1576238" y="7604341"/>
            <a:ext cx="377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60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5EF4A1F2-FDEB-44D9-8313-E6EA30569B90}"/>
              </a:ext>
            </a:extLst>
          </p:cNvPr>
          <p:cNvSpPr txBox="1"/>
          <p:nvPr/>
        </p:nvSpPr>
        <p:spPr>
          <a:xfrm>
            <a:off x="1566461" y="7780629"/>
            <a:ext cx="377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45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28E3F3DD-9051-47DE-A20B-6F8FA8806617}"/>
              </a:ext>
            </a:extLst>
          </p:cNvPr>
          <p:cNvSpPr txBox="1"/>
          <p:nvPr/>
        </p:nvSpPr>
        <p:spPr>
          <a:xfrm>
            <a:off x="1562010" y="8108345"/>
            <a:ext cx="377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35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BDE48717-FCFD-4BFA-8BC1-2D78064665F8}"/>
              </a:ext>
            </a:extLst>
          </p:cNvPr>
          <p:cNvSpPr txBox="1"/>
          <p:nvPr/>
        </p:nvSpPr>
        <p:spPr>
          <a:xfrm>
            <a:off x="1571151" y="8301881"/>
            <a:ext cx="377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25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56AB2797-717C-41D7-AB00-3B8EFD9C9E53}"/>
              </a:ext>
            </a:extLst>
          </p:cNvPr>
          <p:cNvSpPr txBox="1"/>
          <p:nvPr/>
        </p:nvSpPr>
        <p:spPr>
          <a:xfrm>
            <a:off x="1791241" y="8035623"/>
            <a:ext cx="467492" cy="282301"/>
          </a:xfrm>
          <a:prstGeom prst="rect">
            <a:avLst/>
          </a:prstGeom>
          <a:noFill/>
          <a:ln w="28575">
            <a:solidFill>
              <a:srgbClr val="00B0F0"/>
            </a:solidFill>
          </a:ln>
        </p:spPr>
        <p:txBody>
          <a:bodyPr wrap="square" rtlCol="0">
            <a:spAutoFit/>
          </a:bodyPr>
          <a:lstStyle/>
          <a:p>
            <a:endParaRPr lang="it-IT" dirty="0"/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5F96DE17-C0D0-4935-9810-FAC164093822}"/>
              </a:ext>
            </a:extLst>
          </p:cNvPr>
          <p:cNvSpPr txBox="1"/>
          <p:nvPr/>
        </p:nvSpPr>
        <p:spPr>
          <a:xfrm>
            <a:off x="836102" y="7965295"/>
            <a:ext cx="720583" cy="52322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it-IT" sz="1400" dirty="0">
                <a:solidFill>
                  <a:schemeClr val="bg1"/>
                </a:solidFill>
              </a:rPr>
              <a:t>GAPDH</a:t>
            </a:r>
          </a:p>
          <a:p>
            <a:r>
              <a:rPr lang="it-IT" sz="1400" dirty="0">
                <a:solidFill>
                  <a:schemeClr val="bg1"/>
                </a:solidFill>
              </a:rPr>
              <a:t>FIG 2B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E28BA55F-0B08-474A-B8B1-375BE7E167B9}"/>
              </a:ext>
            </a:extLst>
          </p:cNvPr>
          <p:cNvSpPr txBox="1"/>
          <p:nvPr/>
        </p:nvSpPr>
        <p:spPr>
          <a:xfrm>
            <a:off x="754323" y="9034322"/>
            <a:ext cx="14125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ort exposure</a:t>
            </a:r>
          </a:p>
        </p:txBody>
      </p:sp>
    </p:spTree>
    <p:extLst>
      <p:ext uri="{BB962C8B-B14F-4D97-AF65-F5344CB8AC3E}">
        <p14:creationId xmlns:p14="http://schemas.microsoft.com/office/powerpoint/2010/main" val="90619364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E028ECC-E705-4C26-BB81-D5B18BC066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it-IT"/>
          </a:p>
        </p:txBody>
      </p:sp>
      <p:pic>
        <p:nvPicPr>
          <p:cNvPr id="4" name="Immagine 3">
            <a:extLst>
              <a:ext uri="{FF2B5EF4-FFF2-40B4-BE49-F238E27FC236}">
                <a16:creationId xmlns:a16="http://schemas.microsoft.com/office/drawing/2014/main" id="{F9A9807F-D1AD-4332-8B20-4BF57BDC270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2911" y="167807"/>
            <a:ext cx="5372178" cy="43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D0193858-6154-469A-BE02-4148B3251D4D}"/>
              </a:ext>
            </a:extLst>
          </p:cNvPr>
          <p:cNvSpPr txBox="1"/>
          <p:nvPr/>
        </p:nvSpPr>
        <p:spPr>
          <a:xfrm>
            <a:off x="2495550" y="2506161"/>
            <a:ext cx="348128" cy="26170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it-IT" sz="1400" dirty="0"/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D63F4492-D902-455B-8271-87C7FBB7CA7A}"/>
              </a:ext>
            </a:extLst>
          </p:cNvPr>
          <p:cNvSpPr txBox="1"/>
          <p:nvPr/>
        </p:nvSpPr>
        <p:spPr>
          <a:xfrm>
            <a:off x="1227299" y="2222679"/>
            <a:ext cx="1132540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it-IT" dirty="0"/>
              <a:t>SMAD3</a:t>
            </a:r>
          </a:p>
          <a:p>
            <a:r>
              <a:rPr lang="it-IT" dirty="0"/>
              <a:t>SMAD2</a:t>
            </a:r>
          </a:p>
          <a:p>
            <a:r>
              <a:rPr lang="it-IT" dirty="0"/>
              <a:t>FIG 2B</a:t>
            </a:r>
          </a:p>
        </p:txBody>
      </p:sp>
      <p:pic>
        <p:nvPicPr>
          <p:cNvPr id="14" name="Immagine 13">
            <a:extLst>
              <a:ext uri="{FF2B5EF4-FFF2-40B4-BE49-F238E27FC236}">
                <a16:creationId xmlns:a16="http://schemas.microsoft.com/office/drawing/2014/main" id="{B7C8C2B1-F9E5-4ECB-BC7B-F017810B0A7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9863" y="4717245"/>
            <a:ext cx="5378271" cy="4284565"/>
          </a:xfrm>
          <a:prstGeom prst="rect">
            <a:avLst/>
          </a:prstGeom>
        </p:spPr>
      </p:pic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646C366B-1014-4FAC-9132-6469D254D84D}"/>
              </a:ext>
            </a:extLst>
          </p:cNvPr>
          <p:cNvSpPr txBox="1"/>
          <p:nvPr/>
        </p:nvSpPr>
        <p:spPr>
          <a:xfrm>
            <a:off x="2495550" y="7039157"/>
            <a:ext cx="442256" cy="369332"/>
          </a:xfrm>
          <a:prstGeom prst="rect">
            <a:avLst/>
          </a:prstGeom>
          <a:noFill/>
          <a:ln w="28575">
            <a:solidFill>
              <a:srgbClr val="00B0F0"/>
            </a:solidFill>
          </a:ln>
        </p:spPr>
        <p:txBody>
          <a:bodyPr wrap="square" rtlCol="0">
            <a:spAutoFit/>
          </a:bodyPr>
          <a:lstStyle/>
          <a:p>
            <a:endParaRPr lang="it-IT" dirty="0"/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589FDF5F-3BB2-48A1-9133-76C257C51C87}"/>
              </a:ext>
            </a:extLst>
          </p:cNvPr>
          <p:cNvSpPr txBox="1"/>
          <p:nvPr/>
        </p:nvSpPr>
        <p:spPr>
          <a:xfrm>
            <a:off x="3286530" y="5207274"/>
            <a:ext cx="1132540" cy="92333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it-IT" dirty="0">
                <a:solidFill>
                  <a:schemeClr val="bg1"/>
                </a:solidFill>
              </a:rPr>
              <a:t>SMAD3</a:t>
            </a:r>
          </a:p>
          <a:p>
            <a:r>
              <a:rPr lang="it-IT" dirty="0">
                <a:solidFill>
                  <a:schemeClr val="bg1"/>
                </a:solidFill>
              </a:rPr>
              <a:t>SMAD2</a:t>
            </a:r>
          </a:p>
          <a:p>
            <a:r>
              <a:rPr lang="it-IT" dirty="0">
                <a:solidFill>
                  <a:schemeClr val="bg1"/>
                </a:solidFill>
              </a:rPr>
              <a:t>FIG 2D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D2A6717F-E5E2-4653-B710-A5B427B776EC}"/>
              </a:ext>
            </a:extLst>
          </p:cNvPr>
          <p:cNvSpPr txBox="1"/>
          <p:nvPr/>
        </p:nvSpPr>
        <p:spPr>
          <a:xfrm>
            <a:off x="902252" y="8614758"/>
            <a:ext cx="14125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dium exposure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52766900-3379-49C7-948A-380DBE674144}"/>
              </a:ext>
            </a:extLst>
          </p:cNvPr>
          <p:cNvSpPr txBox="1"/>
          <p:nvPr/>
        </p:nvSpPr>
        <p:spPr>
          <a:xfrm>
            <a:off x="2324549" y="6998249"/>
            <a:ext cx="3161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60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BF225891-FF76-43CD-B58D-2D9EDCD6D379}"/>
              </a:ext>
            </a:extLst>
          </p:cNvPr>
          <p:cNvSpPr txBox="1"/>
          <p:nvPr/>
        </p:nvSpPr>
        <p:spPr>
          <a:xfrm>
            <a:off x="2314772" y="7249352"/>
            <a:ext cx="3161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45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02A7248E-D714-4CAC-BC8E-0C5701B9A2E6}"/>
              </a:ext>
            </a:extLst>
          </p:cNvPr>
          <p:cNvSpPr txBox="1"/>
          <p:nvPr/>
        </p:nvSpPr>
        <p:spPr>
          <a:xfrm>
            <a:off x="2328249" y="7515753"/>
            <a:ext cx="3161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35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CCBD36A5-C44C-4D35-B1F9-F5EFBEF29217}"/>
              </a:ext>
            </a:extLst>
          </p:cNvPr>
          <p:cNvSpPr txBox="1"/>
          <p:nvPr/>
        </p:nvSpPr>
        <p:spPr>
          <a:xfrm>
            <a:off x="2319462" y="7695789"/>
            <a:ext cx="3161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25</a:t>
            </a:r>
          </a:p>
        </p:txBody>
      </p:sp>
    </p:spTree>
    <p:extLst>
      <p:ext uri="{BB962C8B-B14F-4D97-AF65-F5344CB8AC3E}">
        <p14:creationId xmlns:p14="http://schemas.microsoft.com/office/powerpoint/2010/main" val="330349630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27AF8A63-B975-4812-93BC-4B591BB0ABB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22003" y="272180"/>
            <a:ext cx="5413993" cy="43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id="{E70045B3-FAC2-4B83-AA19-6CEF5EA7B463}"/>
              </a:ext>
            </a:extLst>
          </p:cNvPr>
          <p:cNvSpPr txBox="1"/>
          <p:nvPr/>
        </p:nvSpPr>
        <p:spPr>
          <a:xfrm>
            <a:off x="1904254" y="3141213"/>
            <a:ext cx="467471" cy="20206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it-IT" dirty="0"/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7871C0EB-DF5A-4BC7-A210-D36C51D167C0}"/>
              </a:ext>
            </a:extLst>
          </p:cNvPr>
          <p:cNvSpPr txBox="1"/>
          <p:nvPr/>
        </p:nvSpPr>
        <p:spPr>
          <a:xfrm>
            <a:off x="867336" y="3639346"/>
            <a:ext cx="1036918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it-IT" dirty="0"/>
              <a:t>SNAIL</a:t>
            </a:r>
          </a:p>
          <a:p>
            <a:r>
              <a:rPr lang="it-IT" dirty="0"/>
              <a:t>FIG 2B</a:t>
            </a:r>
          </a:p>
        </p:txBody>
      </p:sp>
      <p:pic>
        <p:nvPicPr>
          <p:cNvPr id="5" name="Immagine 4">
            <a:extLst>
              <a:ext uri="{FF2B5EF4-FFF2-40B4-BE49-F238E27FC236}">
                <a16:creationId xmlns:a16="http://schemas.microsoft.com/office/drawing/2014/main" id="{04E4E9DB-58B0-4CFE-9122-BDD42298E4E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22003" y="4687966"/>
            <a:ext cx="5413993" cy="4809807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ADC9FF21-C6E2-446F-BDD8-A4EF46DB1A9B}"/>
              </a:ext>
            </a:extLst>
          </p:cNvPr>
          <p:cNvSpPr txBox="1"/>
          <p:nvPr/>
        </p:nvSpPr>
        <p:spPr>
          <a:xfrm>
            <a:off x="1828054" y="7858315"/>
            <a:ext cx="553196" cy="209360"/>
          </a:xfrm>
          <a:prstGeom prst="rect">
            <a:avLst/>
          </a:prstGeom>
          <a:noFill/>
          <a:ln w="28575"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endParaRPr lang="it-IT" dirty="0"/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E3FA977A-EDA6-44F0-94BC-5D3D9A6A47F3}"/>
              </a:ext>
            </a:extLst>
          </p:cNvPr>
          <p:cNvSpPr txBox="1"/>
          <p:nvPr/>
        </p:nvSpPr>
        <p:spPr>
          <a:xfrm>
            <a:off x="756570" y="8067675"/>
            <a:ext cx="796005" cy="64633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it-IT" dirty="0">
                <a:solidFill>
                  <a:schemeClr val="bg1"/>
                </a:solidFill>
              </a:rPr>
              <a:t>SNAIL</a:t>
            </a:r>
          </a:p>
          <a:p>
            <a:r>
              <a:rPr lang="it-IT" dirty="0">
                <a:solidFill>
                  <a:schemeClr val="bg1"/>
                </a:solidFill>
              </a:rPr>
              <a:t>FIG 2B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BD508D8A-61DE-49F3-9446-4C07057D6275}"/>
              </a:ext>
            </a:extLst>
          </p:cNvPr>
          <p:cNvSpPr txBox="1"/>
          <p:nvPr/>
        </p:nvSpPr>
        <p:spPr>
          <a:xfrm>
            <a:off x="1636297" y="8163461"/>
            <a:ext cx="3777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20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992DE234-613B-49D7-8410-52889E280D14}"/>
              </a:ext>
            </a:extLst>
          </p:cNvPr>
          <p:cNvSpPr txBox="1"/>
          <p:nvPr/>
        </p:nvSpPr>
        <p:spPr>
          <a:xfrm>
            <a:off x="1636297" y="7704436"/>
            <a:ext cx="3777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35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7401DB3F-D971-46A3-ABAD-F9EE5B2E52F2}"/>
              </a:ext>
            </a:extLst>
          </p:cNvPr>
          <p:cNvSpPr txBox="1"/>
          <p:nvPr/>
        </p:nvSpPr>
        <p:spPr>
          <a:xfrm>
            <a:off x="1616261" y="7915638"/>
            <a:ext cx="3777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25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D15040B7-3DE5-4EB4-8BBF-B9485B555A6B}"/>
              </a:ext>
            </a:extLst>
          </p:cNvPr>
          <p:cNvSpPr txBox="1"/>
          <p:nvPr/>
        </p:nvSpPr>
        <p:spPr>
          <a:xfrm>
            <a:off x="1636297" y="8489410"/>
            <a:ext cx="3777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15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F9854BAC-125C-4456-B9FC-1EAB5D323D47}"/>
              </a:ext>
            </a:extLst>
          </p:cNvPr>
          <p:cNvSpPr txBox="1"/>
          <p:nvPr/>
        </p:nvSpPr>
        <p:spPr>
          <a:xfrm>
            <a:off x="756570" y="9199083"/>
            <a:ext cx="14125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dium exposure</a:t>
            </a:r>
          </a:p>
        </p:txBody>
      </p:sp>
    </p:spTree>
    <p:extLst>
      <p:ext uri="{BB962C8B-B14F-4D97-AF65-F5344CB8AC3E}">
        <p14:creationId xmlns:p14="http://schemas.microsoft.com/office/powerpoint/2010/main" val="72418267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3688175B-5095-402F-8699-E4872440C2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6441" y="242759"/>
            <a:ext cx="5405118" cy="43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A7212A09-BC30-4332-A530-EEC1356DEFE8}"/>
              </a:ext>
            </a:extLst>
          </p:cNvPr>
          <p:cNvSpPr txBox="1"/>
          <p:nvPr/>
        </p:nvSpPr>
        <p:spPr>
          <a:xfrm>
            <a:off x="3577597" y="2805644"/>
            <a:ext cx="450252" cy="31902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it-IT" dirty="0"/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5518167E-3CAE-46FC-BF19-BBA7F0FC9AA8}"/>
              </a:ext>
            </a:extLst>
          </p:cNvPr>
          <p:cNvSpPr txBox="1"/>
          <p:nvPr/>
        </p:nvSpPr>
        <p:spPr>
          <a:xfrm>
            <a:off x="3472642" y="3314912"/>
            <a:ext cx="83855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it-IT" dirty="0"/>
              <a:t>HSP90</a:t>
            </a:r>
          </a:p>
          <a:p>
            <a:r>
              <a:rPr lang="it-IT" dirty="0"/>
              <a:t>FIG 2B</a:t>
            </a: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CBAD91FF-4906-42B4-AF47-17660FA584F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7084" y="4753003"/>
            <a:ext cx="6582059" cy="4104107"/>
          </a:xfrm>
          <a:prstGeom prst="rect">
            <a:avLst/>
          </a:prstGeom>
        </p:spPr>
      </p:pic>
      <p:sp>
        <p:nvSpPr>
          <p:cNvPr id="8" name="CasellaDiTesto 7">
            <a:extLst>
              <a:ext uri="{FF2B5EF4-FFF2-40B4-BE49-F238E27FC236}">
                <a16:creationId xmlns:a16="http://schemas.microsoft.com/office/drawing/2014/main" id="{99F0E60F-18D7-43FC-8212-BE877EFB2CC9}"/>
              </a:ext>
            </a:extLst>
          </p:cNvPr>
          <p:cNvSpPr txBox="1"/>
          <p:nvPr/>
        </p:nvSpPr>
        <p:spPr>
          <a:xfrm>
            <a:off x="5665795" y="7991419"/>
            <a:ext cx="412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75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A6C87F64-37CE-4F3A-A851-06B7A38FEEC1}"/>
              </a:ext>
            </a:extLst>
          </p:cNvPr>
          <p:cNvSpPr txBox="1"/>
          <p:nvPr/>
        </p:nvSpPr>
        <p:spPr>
          <a:xfrm>
            <a:off x="5633070" y="7807232"/>
            <a:ext cx="4599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100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BD71DBBB-0B07-4010-9F33-3B0E90304637}"/>
              </a:ext>
            </a:extLst>
          </p:cNvPr>
          <p:cNvSpPr txBox="1"/>
          <p:nvPr/>
        </p:nvSpPr>
        <p:spPr>
          <a:xfrm>
            <a:off x="5633070" y="7641040"/>
            <a:ext cx="4599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140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90F68231-307A-4041-8E1C-AD0CAD3D740E}"/>
              </a:ext>
            </a:extLst>
          </p:cNvPr>
          <p:cNvSpPr txBox="1"/>
          <p:nvPr/>
        </p:nvSpPr>
        <p:spPr>
          <a:xfrm>
            <a:off x="5622785" y="7540999"/>
            <a:ext cx="4599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180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0500AB73-2885-480E-97D6-C261C0F0CC1A}"/>
              </a:ext>
            </a:extLst>
          </p:cNvPr>
          <p:cNvSpPr txBox="1"/>
          <p:nvPr/>
        </p:nvSpPr>
        <p:spPr>
          <a:xfrm>
            <a:off x="3495082" y="7826282"/>
            <a:ext cx="1015210" cy="327001"/>
          </a:xfrm>
          <a:prstGeom prst="rect">
            <a:avLst/>
          </a:prstGeom>
          <a:noFill/>
          <a:ln w="28575">
            <a:solidFill>
              <a:srgbClr val="00B0F0"/>
            </a:solidFill>
          </a:ln>
        </p:spPr>
        <p:txBody>
          <a:bodyPr wrap="square" rtlCol="0">
            <a:spAutoFit/>
          </a:bodyPr>
          <a:lstStyle/>
          <a:p>
            <a:endParaRPr lang="it-IT" dirty="0"/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95DCD4B9-AFFE-4244-A8D1-25D590C56FEB}"/>
              </a:ext>
            </a:extLst>
          </p:cNvPr>
          <p:cNvSpPr txBox="1"/>
          <p:nvPr/>
        </p:nvSpPr>
        <p:spPr>
          <a:xfrm>
            <a:off x="3583412" y="8189336"/>
            <a:ext cx="838550" cy="64633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it-IT" dirty="0">
                <a:solidFill>
                  <a:schemeClr val="bg1"/>
                </a:solidFill>
              </a:rPr>
              <a:t>HSP90</a:t>
            </a:r>
          </a:p>
          <a:p>
            <a:r>
              <a:rPr lang="it-IT" dirty="0">
                <a:solidFill>
                  <a:schemeClr val="bg1"/>
                </a:solidFill>
              </a:rPr>
              <a:t>FIG 2B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F3B34245-BFC0-4CF0-A8C2-F9798C59F74F}"/>
              </a:ext>
            </a:extLst>
          </p:cNvPr>
          <p:cNvSpPr txBox="1"/>
          <p:nvPr/>
        </p:nvSpPr>
        <p:spPr>
          <a:xfrm>
            <a:off x="148857" y="8589446"/>
            <a:ext cx="14125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ort exposure</a:t>
            </a:r>
          </a:p>
        </p:txBody>
      </p:sp>
    </p:spTree>
    <p:extLst>
      <p:ext uri="{BB962C8B-B14F-4D97-AF65-F5344CB8AC3E}">
        <p14:creationId xmlns:p14="http://schemas.microsoft.com/office/powerpoint/2010/main" val="180541085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D8DD2A1C-9178-441D-A95E-C29D0561C31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1969" y="439289"/>
            <a:ext cx="5384789" cy="43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id="{46796D1A-649D-4A0E-B210-A8F06458CE57}"/>
              </a:ext>
            </a:extLst>
          </p:cNvPr>
          <p:cNvSpPr txBox="1"/>
          <p:nvPr/>
        </p:nvSpPr>
        <p:spPr>
          <a:xfrm>
            <a:off x="3732928" y="2894665"/>
            <a:ext cx="485653" cy="190734"/>
          </a:xfrm>
          <a:prstGeom prst="rect">
            <a:avLst/>
          </a:prstGeom>
          <a:noFill/>
          <a:ln w="28575">
            <a:solidFill>
              <a:srgbClr val="00B0F0"/>
            </a:solidFill>
          </a:ln>
        </p:spPr>
        <p:txBody>
          <a:bodyPr wrap="square" rtlCol="0">
            <a:spAutoFit/>
          </a:bodyPr>
          <a:lstStyle/>
          <a:p>
            <a:endParaRPr lang="it-IT" dirty="0"/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54BA3FBC-FE72-4CB5-9BBE-17605FA8F329}"/>
              </a:ext>
            </a:extLst>
          </p:cNvPr>
          <p:cNvSpPr txBox="1"/>
          <p:nvPr/>
        </p:nvSpPr>
        <p:spPr>
          <a:xfrm>
            <a:off x="3620732" y="3548549"/>
            <a:ext cx="1036918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it-IT" dirty="0"/>
              <a:t>E-CAD</a:t>
            </a:r>
          </a:p>
          <a:p>
            <a:r>
              <a:rPr lang="it-IT" dirty="0"/>
              <a:t>FIG 2D</a:t>
            </a:r>
          </a:p>
        </p:txBody>
      </p:sp>
      <p:pic>
        <p:nvPicPr>
          <p:cNvPr id="5" name="Immagine 4">
            <a:extLst>
              <a:ext uri="{FF2B5EF4-FFF2-40B4-BE49-F238E27FC236}">
                <a16:creationId xmlns:a16="http://schemas.microsoft.com/office/drawing/2014/main" id="{69953EE9-0DD2-4270-9EAA-F1A603B4436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1479" y="4953000"/>
            <a:ext cx="6575042" cy="4108043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8FBF6807-149A-406A-B31F-CFC3490B5922}"/>
              </a:ext>
            </a:extLst>
          </p:cNvPr>
          <p:cNvSpPr txBox="1"/>
          <p:nvPr/>
        </p:nvSpPr>
        <p:spPr>
          <a:xfrm>
            <a:off x="4341224" y="8362882"/>
            <a:ext cx="822889" cy="584775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it-IT" sz="1600" dirty="0">
                <a:solidFill>
                  <a:schemeClr val="bg1"/>
                </a:solidFill>
              </a:rPr>
              <a:t>E-CAD</a:t>
            </a:r>
          </a:p>
          <a:p>
            <a:r>
              <a:rPr lang="it-IT" sz="1600" dirty="0">
                <a:solidFill>
                  <a:schemeClr val="bg1"/>
                </a:solidFill>
              </a:rPr>
              <a:t>FIG 2B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BE0B39C2-88A3-4627-986E-D59FA35AC52D}"/>
              </a:ext>
            </a:extLst>
          </p:cNvPr>
          <p:cNvSpPr txBox="1"/>
          <p:nvPr/>
        </p:nvSpPr>
        <p:spPr>
          <a:xfrm>
            <a:off x="4137748" y="7649317"/>
            <a:ext cx="1070320" cy="501875"/>
          </a:xfrm>
          <a:prstGeom prst="rect">
            <a:avLst/>
          </a:prstGeom>
          <a:noFill/>
          <a:ln w="28575">
            <a:solidFill>
              <a:srgbClr val="00B0F0"/>
            </a:solidFill>
          </a:ln>
        </p:spPr>
        <p:txBody>
          <a:bodyPr wrap="square" rtlCol="0">
            <a:spAutoFit/>
          </a:bodyPr>
          <a:lstStyle/>
          <a:p>
            <a:endParaRPr lang="it-IT" dirty="0"/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326C85D4-DBA4-4C1C-80DD-9DE5BE7C1EB5}"/>
              </a:ext>
            </a:extLst>
          </p:cNvPr>
          <p:cNvSpPr txBox="1"/>
          <p:nvPr/>
        </p:nvSpPr>
        <p:spPr>
          <a:xfrm>
            <a:off x="5310080" y="7981915"/>
            <a:ext cx="3854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75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AEE405D9-E4A0-49A8-9935-216CA58E84AE}"/>
              </a:ext>
            </a:extLst>
          </p:cNvPr>
          <p:cNvSpPr txBox="1"/>
          <p:nvPr/>
        </p:nvSpPr>
        <p:spPr>
          <a:xfrm>
            <a:off x="5310080" y="7796364"/>
            <a:ext cx="431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100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9B5BD388-063B-4CE7-80FA-05DA6D743FD6}"/>
              </a:ext>
            </a:extLst>
          </p:cNvPr>
          <p:cNvSpPr txBox="1"/>
          <p:nvPr/>
        </p:nvSpPr>
        <p:spPr>
          <a:xfrm>
            <a:off x="5310080" y="7645147"/>
            <a:ext cx="431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140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42B2DAAC-032B-4147-B216-F63D915FE2AB}"/>
              </a:ext>
            </a:extLst>
          </p:cNvPr>
          <p:cNvSpPr txBox="1"/>
          <p:nvPr/>
        </p:nvSpPr>
        <p:spPr>
          <a:xfrm>
            <a:off x="5310080" y="7538845"/>
            <a:ext cx="4316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180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2A1A402E-3029-44FD-9506-F76CF20ED36F}"/>
              </a:ext>
            </a:extLst>
          </p:cNvPr>
          <p:cNvSpPr txBox="1"/>
          <p:nvPr/>
        </p:nvSpPr>
        <p:spPr>
          <a:xfrm>
            <a:off x="3245130" y="8635019"/>
            <a:ext cx="14125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ng exposure</a:t>
            </a:r>
          </a:p>
        </p:txBody>
      </p:sp>
    </p:spTree>
    <p:extLst>
      <p:ext uri="{BB962C8B-B14F-4D97-AF65-F5344CB8AC3E}">
        <p14:creationId xmlns:p14="http://schemas.microsoft.com/office/powerpoint/2010/main" val="137451237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167BCE04-51ED-44A5-A36B-0B2184558E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1314" y="297217"/>
            <a:ext cx="5401281" cy="43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id="{EB4194D4-D814-4F29-88EF-393540B40D39}"/>
              </a:ext>
            </a:extLst>
          </p:cNvPr>
          <p:cNvSpPr txBox="1"/>
          <p:nvPr/>
        </p:nvSpPr>
        <p:spPr>
          <a:xfrm>
            <a:off x="3518241" y="2582314"/>
            <a:ext cx="468000" cy="2520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it-IT" dirty="0"/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26AFF11E-6519-4005-96BE-B30279C60FC5}"/>
              </a:ext>
            </a:extLst>
          </p:cNvPr>
          <p:cNvSpPr txBox="1"/>
          <p:nvPr/>
        </p:nvSpPr>
        <p:spPr>
          <a:xfrm>
            <a:off x="3321862" y="3450555"/>
            <a:ext cx="113254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it-IT" dirty="0"/>
              <a:t>TGFBRI</a:t>
            </a:r>
          </a:p>
          <a:p>
            <a:r>
              <a:rPr lang="it-IT" dirty="0"/>
              <a:t>FIG 2D</a:t>
            </a:r>
          </a:p>
        </p:txBody>
      </p:sp>
      <p:pic>
        <p:nvPicPr>
          <p:cNvPr id="5" name="Immagine 4">
            <a:extLst>
              <a:ext uri="{FF2B5EF4-FFF2-40B4-BE49-F238E27FC236}">
                <a16:creationId xmlns:a16="http://schemas.microsoft.com/office/drawing/2014/main" id="{5A88E56E-BB82-4BEF-9FCE-6759C4E7892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4482" y="4866153"/>
            <a:ext cx="5409697" cy="4284671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C5648100-47B3-4285-B13E-BDE87CA330BF}"/>
              </a:ext>
            </a:extLst>
          </p:cNvPr>
          <p:cNvSpPr txBox="1"/>
          <p:nvPr/>
        </p:nvSpPr>
        <p:spPr>
          <a:xfrm>
            <a:off x="3563961" y="7212091"/>
            <a:ext cx="422280" cy="144000"/>
          </a:xfrm>
          <a:prstGeom prst="rect">
            <a:avLst/>
          </a:prstGeom>
          <a:noFill/>
          <a:ln w="28575">
            <a:solidFill>
              <a:srgbClr val="00B0F0"/>
            </a:solidFill>
          </a:ln>
        </p:spPr>
        <p:txBody>
          <a:bodyPr wrap="square" rtlCol="0">
            <a:spAutoFit/>
          </a:bodyPr>
          <a:lstStyle/>
          <a:p>
            <a:endParaRPr lang="it-IT" dirty="0"/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CCCA6831-B447-446D-B3F6-767F6D63B7A8}"/>
              </a:ext>
            </a:extLst>
          </p:cNvPr>
          <p:cNvSpPr txBox="1"/>
          <p:nvPr/>
        </p:nvSpPr>
        <p:spPr>
          <a:xfrm>
            <a:off x="3419971" y="6141439"/>
            <a:ext cx="1132540" cy="64633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it-IT" dirty="0">
                <a:solidFill>
                  <a:schemeClr val="bg1"/>
                </a:solidFill>
              </a:rPr>
              <a:t>TGFBRI</a:t>
            </a:r>
          </a:p>
          <a:p>
            <a:r>
              <a:rPr lang="it-IT" dirty="0">
                <a:solidFill>
                  <a:schemeClr val="bg1"/>
                </a:solidFill>
              </a:rPr>
              <a:t>FIG 2D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E8E9DA80-58F0-446F-A7BE-28372B270644}"/>
              </a:ext>
            </a:extLst>
          </p:cNvPr>
          <p:cNvSpPr txBox="1"/>
          <p:nvPr/>
        </p:nvSpPr>
        <p:spPr>
          <a:xfrm>
            <a:off x="3518241" y="8140413"/>
            <a:ext cx="14125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dium exposure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60C4CD45-34B9-4C28-A7D4-A9CF1B253BBD}"/>
              </a:ext>
            </a:extLst>
          </p:cNvPr>
          <p:cNvSpPr txBox="1"/>
          <p:nvPr/>
        </p:nvSpPr>
        <p:spPr>
          <a:xfrm>
            <a:off x="3429747" y="7060202"/>
            <a:ext cx="3519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60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BFBD18BE-19F8-460F-B8EE-B4E0CEA03A16}"/>
              </a:ext>
            </a:extLst>
          </p:cNvPr>
          <p:cNvSpPr txBox="1"/>
          <p:nvPr/>
        </p:nvSpPr>
        <p:spPr>
          <a:xfrm>
            <a:off x="3419970" y="7307149"/>
            <a:ext cx="3519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45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8BAD9B9F-F635-44C8-B21F-FE8E26F93475}"/>
              </a:ext>
            </a:extLst>
          </p:cNvPr>
          <p:cNvSpPr txBox="1"/>
          <p:nvPr/>
        </p:nvSpPr>
        <p:spPr>
          <a:xfrm>
            <a:off x="3425135" y="7573550"/>
            <a:ext cx="3519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35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FB48F0AF-D027-4C68-A01C-E9B134AE9CD2}"/>
              </a:ext>
            </a:extLst>
          </p:cNvPr>
          <p:cNvSpPr txBox="1"/>
          <p:nvPr/>
        </p:nvSpPr>
        <p:spPr>
          <a:xfrm>
            <a:off x="3419970" y="6947120"/>
            <a:ext cx="3519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75</a:t>
            </a:r>
          </a:p>
        </p:txBody>
      </p:sp>
    </p:spTree>
    <p:extLst>
      <p:ext uri="{BB962C8B-B14F-4D97-AF65-F5344CB8AC3E}">
        <p14:creationId xmlns:p14="http://schemas.microsoft.com/office/powerpoint/2010/main" val="249329203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119</TotalTime>
  <Words>164</Words>
  <Application>Microsoft Office PowerPoint</Application>
  <PresentationFormat>A4 (21x29,7 cm)</PresentationFormat>
  <Paragraphs>120</Paragraphs>
  <Slides>13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3</vt:i4>
      </vt:variant>
    </vt:vector>
  </HeadingPairs>
  <TitlesOfParts>
    <vt:vector size="17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lavia Trionfetti</dc:creator>
  <cp:lastModifiedBy>Giulio Bontempi</cp:lastModifiedBy>
  <cp:revision>152</cp:revision>
  <dcterms:created xsi:type="dcterms:W3CDTF">2023-07-29T17:11:33Z</dcterms:created>
  <dcterms:modified xsi:type="dcterms:W3CDTF">2025-05-26T13:26:06Z</dcterms:modified>
</cp:coreProperties>
</file>